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911D04B-86BC-4679-AB85-14B2EA7E00AD}" v="18" dt="2020-12-27T22:23:24.53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3" d="100"/>
          <a:sy n="63" d="100"/>
        </p:scale>
        <p:origin x="76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佐々木　那津" userId="5647839a-84e7-46f4-98c7-f61dea668ef3" providerId="ADAL" clId="{0911D04B-86BC-4679-AB85-14B2EA7E00AD}"/>
    <pc:docChg chg="undo custSel modSld">
      <pc:chgData name="佐々木　那津" userId="5647839a-84e7-46f4-98c7-f61dea668ef3" providerId="ADAL" clId="{0911D04B-86BC-4679-AB85-14B2EA7E00AD}" dt="2020-12-27T22:34:08.497" v="246" actId="1076"/>
      <pc:docMkLst>
        <pc:docMk/>
      </pc:docMkLst>
      <pc:sldChg chg="addSp modSp mod">
        <pc:chgData name="佐々木　那津" userId="5647839a-84e7-46f4-98c7-f61dea668ef3" providerId="ADAL" clId="{0911D04B-86BC-4679-AB85-14B2EA7E00AD}" dt="2020-12-27T22:34:08.497" v="246" actId="1076"/>
        <pc:sldMkLst>
          <pc:docMk/>
          <pc:sldMk cId="1913556460" sldId="256"/>
        </pc:sldMkLst>
        <pc:spChg chg="add mod">
          <ac:chgData name="佐々木　那津" userId="5647839a-84e7-46f4-98c7-f61dea668ef3" providerId="ADAL" clId="{0911D04B-86BC-4679-AB85-14B2EA7E00AD}" dt="2020-12-27T22:11:17.664" v="32" actId="1076"/>
          <ac:spMkLst>
            <pc:docMk/>
            <pc:sldMk cId="1913556460" sldId="256"/>
            <ac:spMk id="5" creationId="{6614EF1C-D738-4A81-98AD-2ABD74FCC58F}"/>
          </ac:spMkLst>
        </pc:spChg>
        <pc:spChg chg="add mod">
          <ac:chgData name="佐々木　那津" userId="5647839a-84e7-46f4-98c7-f61dea668ef3" providerId="ADAL" clId="{0911D04B-86BC-4679-AB85-14B2EA7E00AD}" dt="2020-12-27T22:12:49.877" v="156" actId="1076"/>
          <ac:spMkLst>
            <pc:docMk/>
            <pc:sldMk cId="1913556460" sldId="256"/>
            <ac:spMk id="6" creationId="{55CBBAC5-8E86-412A-B3CB-35D04A8A10CE}"/>
          </ac:spMkLst>
        </pc:spChg>
        <pc:spChg chg="add mod">
          <ac:chgData name="佐々木　那津" userId="5647839a-84e7-46f4-98c7-f61dea668ef3" providerId="ADAL" clId="{0911D04B-86BC-4679-AB85-14B2EA7E00AD}" dt="2020-12-27T22:21:33.715" v="190" actId="1076"/>
          <ac:spMkLst>
            <pc:docMk/>
            <pc:sldMk cId="1913556460" sldId="256"/>
            <ac:spMk id="12" creationId="{36598665-3EE4-4805-80D2-78E01F144778}"/>
          </ac:spMkLst>
        </pc:spChg>
        <pc:spChg chg="add mod">
          <ac:chgData name="佐々木　那津" userId="5647839a-84e7-46f4-98c7-f61dea668ef3" providerId="ADAL" clId="{0911D04B-86BC-4679-AB85-14B2EA7E00AD}" dt="2020-12-27T22:33:49.511" v="243" actId="1076"/>
          <ac:spMkLst>
            <pc:docMk/>
            <pc:sldMk cId="1913556460" sldId="256"/>
            <ac:spMk id="13" creationId="{F28CA180-1822-4E29-8FCF-F4933096E46F}"/>
          </ac:spMkLst>
        </pc:spChg>
        <pc:spChg chg="add mod">
          <ac:chgData name="佐々木　那津" userId="5647839a-84e7-46f4-98c7-f61dea668ef3" providerId="ADAL" clId="{0911D04B-86BC-4679-AB85-14B2EA7E00AD}" dt="2020-12-27T22:33:57.089" v="245" actId="1076"/>
          <ac:spMkLst>
            <pc:docMk/>
            <pc:sldMk cId="1913556460" sldId="256"/>
            <ac:spMk id="14" creationId="{95CED43E-0003-4AEE-94A3-4862CB6510D2}"/>
          </ac:spMkLst>
        </pc:spChg>
        <pc:spChg chg="add mod">
          <ac:chgData name="佐々木　那津" userId="5647839a-84e7-46f4-98c7-f61dea668ef3" providerId="ADAL" clId="{0911D04B-86BC-4679-AB85-14B2EA7E00AD}" dt="2020-12-27T22:33:37.589" v="240" actId="1076"/>
          <ac:spMkLst>
            <pc:docMk/>
            <pc:sldMk cId="1913556460" sldId="256"/>
            <ac:spMk id="15" creationId="{16138E56-A2B7-4883-88E7-00C569CE8F98}"/>
          </ac:spMkLst>
        </pc:spChg>
        <pc:spChg chg="add mod">
          <ac:chgData name="佐々木　那津" userId="5647839a-84e7-46f4-98c7-f61dea668ef3" providerId="ADAL" clId="{0911D04B-86BC-4679-AB85-14B2EA7E00AD}" dt="2020-12-27T22:23:02.512" v="217"/>
          <ac:spMkLst>
            <pc:docMk/>
            <pc:sldMk cId="1913556460" sldId="256"/>
            <ac:spMk id="16" creationId="{CA41FA2B-D3E1-4513-A63E-D7236330E9A3}"/>
          </ac:spMkLst>
        </pc:spChg>
        <pc:spChg chg="add mod">
          <ac:chgData name="佐々木　那津" userId="5647839a-84e7-46f4-98c7-f61dea668ef3" providerId="ADAL" clId="{0911D04B-86BC-4679-AB85-14B2EA7E00AD}" dt="2020-12-27T22:34:08.497" v="246" actId="1076"/>
          <ac:spMkLst>
            <pc:docMk/>
            <pc:sldMk cId="1913556460" sldId="256"/>
            <ac:spMk id="17" creationId="{0968572E-A5BC-47E9-9252-F988AA10E0D7}"/>
          </ac:spMkLst>
        </pc:spChg>
        <pc:spChg chg="add mod">
          <ac:chgData name="佐々木　那津" userId="5647839a-84e7-46f4-98c7-f61dea668ef3" providerId="ADAL" clId="{0911D04B-86BC-4679-AB85-14B2EA7E00AD}" dt="2020-12-27T22:33:52.778" v="244" actId="1076"/>
          <ac:spMkLst>
            <pc:docMk/>
            <pc:sldMk cId="1913556460" sldId="256"/>
            <ac:spMk id="18" creationId="{63401DD7-5127-449C-985C-A432FF424282}"/>
          </ac:spMkLst>
        </pc:spChg>
        <pc:spChg chg="add mod">
          <ac:chgData name="佐々木　那津" userId="5647839a-84e7-46f4-98c7-f61dea668ef3" providerId="ADAL" clId="{0911D04B-86BC-4679-AB85-14B2EA7E00AD}" dt="2020-12-27T22:33:40.075" v="241" actId="1076"/>
          <ac:spMkLst>
            <pc:docMk/>
            <pc:sldMk cId="1913556460" sldId="256"/>
            <ac:spMk id="19" creationId="{8D7964A8-BF4F-4789-8B4B-22757FD72E27}"/>
          </ac:spMkLst>
        </pc:spChg>
        <pc:graphicFrameChg chg="mod">
          <ac:chgData name="佐々木　那津" userId="5647839a-84e7-46f4-98c7-f61dea668ef3" providerId="ADAL" clId="{0911D04B-86BC-4679-AB85-14B2EA7E00AD}" dt="2020-12-27T22:16:45.966" v="178"/>
          <ac:graphicFrameMkLst>
            <pc:docMk/>
            <pc:sldMk cId="1913556460" sldId="256"/>
            <ac:graphicFrameMk id="4" creationId="{4C7038FF-DEFE-4590-80E9-4D93922978CF}"/>
          </ac:graphicFrameMkLst>
        </pc:graphicFrameChg>
        <pc:cxnChg chg="add mod">
          <ac:chgData name="佐々木　那津" userId="5647839a-84e7-46f4-98c7-f61dea668ef3" providerId="ADAL" clId="{0911D04B-86BC-4679-AB85-14B2EA7E00AD}" dt="2020-12-27T22:15:21.481" v="164" actId="1076"/>
          <ac:cxnSpMkLst>
            <pc:docMk/>
            <pc:sldMk cId="1913556460" sldId="256"/>
            <ac:cxnSpMk id="8" creationId="{1945CC8C-8D1C-4015-A729-396475AC5434}"/>
          </ac:cxnSpMkLst>
        </pc:cxnChg>
        <pc:cxnChg chg="add mod">
          <ac:chgData name="佐々木　那津" userId="5647839a-84e7-46f4-98c7-f61dea668ef3" providerId="ADAL" clId="{0911D04B-86BC-4679-AB85-14B2EA7E00AD}" dt="2020-12-27T22:15:37.488" v="165" actId="1076"/>
          <ac:cxnSpMkLst>
            <pc:docMk/>
            <pc:sldMk cId="1913556460" sldId="256"/>
            <ac:cxnSpMk id="9" creationId="{24FA7DEE-138D-4900-9430-6E488C5C43F4}"/>
          </ac:cxnSpMkLst>
        </pc:cxnChg>
        <pc:cxnChg chg="add mod">
          <ac:chgData name="佐々木　那津" userId="5647839a-84e7-46f4-98c7-f61dea668ef3" providerId="ADAL" clId="{0911D04B-86BC-4679-AB85-14B2EA7E00AD}" dt="2020-12-27T22:16:03.355" v="167" actId="1076"/>
          <ac:cxnSpMkLst>
            <pc:docMk/>
            <pc:sldMk cId="1913556460" sldId="256"/>
            <ac:cxnSpMk id="10" creationId="{87E660E2-CCE4-4386-96F7-C8A17955C4EB}"/>
          </ac:cxnSpMkLst>
        </pc:cxnChg>
        <pc:cxnChg chg="add mod">
          <ac:chgData name="佐々木　那津" userId="5647839a-84e7-46f4-98c7-f61dea668ef3" providerId="ADAL" clId="{0911D04B-86BC-4679-AB85-14B2EA7E00AD}" dt="2020-12-27T22:16:22.833" v="169" actId="1076"/>
          <ac:cxnSpMkLst>
            <pc:docMk/>
            <pc:sldMk cId="1913556460" sldId="256"/>
            <ac:cxnSpMk id="11" creationId="{1181D731-360D-4050-948D-FB7C3C39DDA1}"/>
          </ac:cxnSpMkLst>
        </pc:cxn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pcr_positive_daily!$B$1</c:f>
              <c:strCache>
                <c:ptCount val="1"/>
                <c:pt idx="0">
                  <c:v>PCR  positive</c:v>
                </c:pt>
              </c:strCache>
            </c:strRef>
          </c:tx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cat>
            <c:strRef>
              <c:f>pcr_positive_daily!$A$2:$A$301</c:f>
              <c:strCache>
                <c:ptCount val="300"/>
                <c:pt idx="0">
                  <c:v> 2/5</c:v>
                </c:pt>
                <c:pt idx="1">
                  <c:v> 2/6</c:v>
                </c:pt>
                <c:pt idx="2">
                  <c:v> 2/7</c:v>
                </c:pt>
                <c:pt idx="3">
                  <c:v> 2/8</c:v>
                </c:pt>
                <c:pt idx="4">
                  <c:v> 2/9</c:v>
                </c:pt>
                <c:pt idx="5">
                  <c:v> 2/10</c:v>
                </c:pt>
                <c:pt idx="6">
                  <c:v> 2/11</c:v>
                </c:pt>
                <c:pt idx="7">
                  <c:v> 2/12</c:v>
                </c:pt>
                <c:pt idx="8">
                  <c:v> 2/13</c:v>
                </c:pt>
                <c:pt idx="9">
                  <c:v> 2/14</c:v>
                </c:pt>
                <c:pt idx="10">
                  <c:v> 2/15</c:v>
                </c:pt>
                <c:pt idx="11">
                  <c:v> 2/16</c:v>
                </c:pt>
                <c:pt idx="12">
                  <c:v> 2/17</c:v>
                </c:pt>
                <c:pt idx="13">
                  <c:v> 2/18</c:v>
                </c:pt>
                <c:pt idx="14">
                  <c:v> 2/19</c:v>
                </c:pt>
                <c:pt idx="15">
                  <c:v> 2/20</c:v>
                </c:pt>
                <c:pt idx="16">
                  <c:v> 2/21</c:v>
                </c:pt>
                <c:pt idx="17">
                  <c:v> 2/22</c:v>
                </c:pt>
                <c:pt idx="18">
                  <c:v> 2/23</c:v>
                </c:pt>
                <c:pt idx="19">
                  <c:v> 2/24</c:v>
                </c:pt>
                <c:pt idx="20">
                  <c:v> 2/25</c:v>
                </c:pt>
                <c:pt idx="21">
                  <c:v> 2/26</c:v>
                </c:pt>
                <c:pt idx="22">
                  <c:v> 2/27</c:v>
                </c:pt>
                <c:pt idx="23">
                  <c:v> 2/28</c:v>
                </c:pt>
                <c:pt idx="24">
                  <c:v> 2/29</c:v>
                </c:pt>
                <c:pt idx="25">
                  <c:v> 3/1</c:v>
                </c:pt>
                <c:pt idx="26">
                  <c:v> 3/2</c:v>
                </c:pt>
                <c:pt idx="27">
                  <c:v> 3/3</c:v>
                </c:pt>
                <c:pt idx="28">
                  <c:v> 3/4</c:v>
                </c:pt>
                <c:pt idx="29">
                  <c:v> 3/5</c:v>
                </c:pt>
                <c:pt idx="30">
                  <c:v> 3/6</c:v>
                </c:pt>
                <c:pt idx="31">
                  <c:v> 3/7</c:v>
                </c:pt>
                <c:pt idx="32">
                  <c:v> 3/8</c:v>
                </c:pt>
                <c:pt idx="33">
                  <c:v> 3/9</c:v>
                </c:pt>
                <c:pt idx="34">
                  <c:v> 3/10</c:v>
                </c:pt>
                <c:pt idx="35">
                  <c:v> 3/11</c:v>
                </c:pt>
                <c:pt idx="36">
                  <c:v> 3/12</c:v>
                </c:pt>
                <c:pt idx="37">
                  <c:v> 3/13</c:v>
                </c:pt>
                <c:pt idx="38">
                  <c:v> 3/14</c:v>
                </c:pt>
                <c:pt idx="39">
                  <c:v> 3/15</c:v>
                </c:pt>
                <c:pt idx="40">
                  <c:v> 3/16</c:v>
                </c:pt>
                <c:pt idx="41">
                  <c:v> 3/17</c:v>
                </c:pt>
                <c:pt idx="42">
                  <c:v> 3/18</c:v>
                </c:pt>
                <c:pt idx="43">
                  <c:v> 3/19</c:v>
                </c:pt>
                <c:pt idx="44">
                  <c:v> 3/20</c:v>
                </c:pt>
                <c:pt idx="45">
                  <c:v> 3/21</c:v>
                </c:pt>
                <c:pt idx="46">
                  <c:v> 3/22</c:v>
                </c:pt>
                <c:pt idx="47">
                  <c:v> 3/23</c:v>
                </c:pt>
                <c:pt idx="48">
                  <c:v> 3/24</c:v>
                </c:pt>
                <c:pt idx="49">
                  <c:v> 3/25</c:v>
                </c:pt>
                <c:pt idx="50">
                  <c:v> 3/26</c:v>
                </c:pt>
                <c:pt idx="51">
                  <c:v> 3/27</c:v>
                </c:pt>
                <c:pt idx="52">
                  <c:v> 3/28</c:v>
                </c:pt>
                <c:pt idx="53">
                  <c:v> 3/29</c:v>
                </c:pt>
                <c:pt idx="54">
                  <c:v> 3/30</c:v>
                </c:pt>
                <c:pt idx="55">
                  <c:v> 3/31</c:v>
                </c:pt>
                <c:pt idx="56">
                  <c:v> 4/1</c:v>
                </c:pt>
                <c:pt idx="57">
                  <c:v> 4/2</c:v>
                </c:pt>
                <c:pt idx="58">
                  <c:v> 4/3</c:v>
                </c:pt>
                <c:pt idx="59">
                  <c:v> 4/4</c:v>
                </c:pt>
                <c:pt idx="60">
                  <c:v> 4/5</c:v>
                </c:pt>
                <c:pt idx="61">
                  <c:v> 4/6</c:v>
                </c:pt>
                <c:pt idx="62">
                  <c:v> 4/7</c:v>
                </c:pt>
                <c:pt idx="63">
                  <c:v> 4/8</c:v>
                </c:pt>
                <c:pt idx="64">
                  <c:v> 4/9</c:v>
                </c:pt>
                <c:pt idx="65">
                  <c:v> 4/10</c:v>
                </c:pt>
                <c:pt idx="66">
                  <c:v> 4/11</c:v>
                </c:pt>
                <c:pt idx="67">
                  <c:v> 4/12</c:v>
                </c:pt>
                <c:pt idx="68">
                  <c:v> 4/13</c:v>
                </c:pt>
                <c:pt idx="69">
                  <c:v> 4/14</c:v>
                </c:pt>
                <c:pt idx="70">
                  <c:v> 4/15</c:v>
                </c:pt>
                <c:pt idx="71">
                  <c:v> 4/16</c:v>
                </c:pt>
                <c:pt idx="72">
                  <c:v> 4/17</c:v>
                </c:pt>
                <c:pt idx="73">
                  <c:v> 4/18</c:v>
                </c:pt>
                <c:pt idx="74">
                  <c:v> 4/19</c:v>
                </c:pt>
                <c:pt idx="75">
                  <c:v> 4/20</c:v>
                </c:pt>
                <c:pt idx="76">
                  <c:v> 4/21</c:v>
                </c:pt>
                <c:pt idx="77">
                  <c:v> 4/22</c:v>
                </c:pt>
                <c:pt idx="78">
                  <c:v> 4/23</c:v>
                </c:pt>
                <c:pt idx="79">
                  <c:v> 4/24</c:v>
                </c:pt>
                <c:pt idx="80">
                  <c:v> 4/25</c:v>
                </c:pt>
                <c:pt idx="81">
                  <c:v> 4/26</c:v>
                </c:pt>
                <c:pt idx="82">
                  <c:v> 4/27</c:v>
                </c:pt>
                <c:pt idx="83">
                  <c:v> 4/28</c:v>
                </c:pt>
                <c:pt idx="84">
                  <c:v> 4/29</c:v>
                </c:pt>
                <c:pt idx="85">
                  <c:v> 4/30</c:v>
                </c:pt>
                <c:pt idx="86">
                  <c:v> 5/1</c:v>
                </c:pt>
                <c:pt idx="87">
                  <c:v> 5/2</c:v>
                </c:pt>
                <c:pt idx="88">
                  <c:v> 5/3</c:v>
                </c:pt>
                <c:pt idx="89">
                  <c:v> 5/4</c:v>
                </c:pt>
                <c:pt idx="90">
                  <c:v> 5/5</c:v>
                </c:pt>
                <c:pt idx="91">
                  <c:v> 5/6</c:v>
                </c:pt>
                <c:pt idx="92">
                  <c:v> 5/7</c:v>
                </c:pt>
                <c:pt idx="93">
                  <c:v> 5/8</c:v>
                </c:pt>
                <c:pt idx="94">
                  <c:v> 5/9</c:v>
                </c:pt>
                <c:pt idx="95">
                  <c:v> 5/10</c:v>
                </c:pt>
                <c:pt idx="96">
                  <c:v> 5/11</c:v>
                </c:pt>
                <c:pt idx="97">
                  <c:v> 5/12</c:v>
                </c:pt>
                <c:pt idx="98">
                  <c:v> 5/13</c:v>
                </c:pt>
                <c:pt idx="99">
                  <c:v> 5/14</c:v>
                </c:pt>
                <c:pt idx="100">
                  <c:v> 5/15</c:v>
                </c:pt>
                <c:pt idx="101">
                  <c:v> 5/16</c:v>
                </c:pt>
                <c:pt idx="102">
                  <c:v> 5/17</c:v>
                </c:pt>
                <c:pt idx="103">
                  <c:v> 5/18</c:v>
                </c:pt>
                <c:pt idx="104">
                  <c:v> 5/19</c:v>
                </c:pt>
                <c:pt idx="105">
                  <c:v> 5/20</c:v>
                </c:pt>
                <c:pt idx="106">
                  <c:v> 5/21</c:v>
                </c:pt>
                <c:pt idx="107">
                  <c:v> 5/22</c:v>
                </c:pt>
                <c:pt idx="108">
                  <c:v> 5/23</c:v>
                </c:pt>
                <c:pt idx="109">
                  <c:v> 5/24</c:v>
                </c:pt>
                <c:pt idx="110">
                  <c:v> 5/25</c:v>
                </c:pt>
                <c:pt idx="111">
                  <c:v> 5/26</c:v>
                </c:pt>
                <c:pt idx="112">
                  <c:v> 5/27</c:v>
                </c:pt>
                <c:pt idx="113">
                  <c:v> 5/28</c:v>
                </c:pt>
                <c:pt idx="114">
                  <c:v> 5/29</c:v>
                </c:pt>
                <c:pt idx="115">
                  <c:v> 5/30</c:v>
                </c:pt>
                <c:pt idx="116">
                  <c:v> 5/31</c:v>
                </c:pt>
                <c:pt idx="117">
                  <c:v> 6/1</c:v>
                </c:pt>
                <c:pt idx="118">
                  <c:v> 6/2</c:v>
                </c:pt>
                <c:pt idx="119">
                  <c:v> 6/3</c:v>
                </c:pt>
                <c:pt idx="120">
                  <c:v> 6/4</c:v>
                </c:pt>
                <c:pt idx="121">
                  <c:v> 6/5</c:v>
                </c:pt>
                <c:pt idx="122">
                  <c:v> 6/6</c:v>
                </c:pt>
                <c:pt idx="123">
                  <c:v> 6/7</c:v>
                </c:pt>
                <c:pt idx="124">
                  <c:v> 6/8</c:v>
                </c:pt>
                <c:pt idx="125">
                  <c:v> 6/9</c:v>
                </c:pt>
                <c:pt idx="126">
                  <c:v> 6/10</c:v>
                </c:pt>
                <c:pt idx="127">
                  <c:v> 6/11</c:v>
                </c:pt>
                <c:pt idx="128">
                  <c:v> 6/12</c:v>
                </c:pt>
                <c:pt idx="129">
                  <c:v> 6/13</c:v>
                </c:pt>
                <c:pt idx="130">
                  <c:v> 6/14</c:v>
                </c:pt>
                <c:pt idx="131">
                  <c:v> 6/15</c:v>
                </c:pt>
                <c:pt idx="132">
                  <c:v> 6/16</c:v>
                </c:pt>
                <c:pt idx="133">
                  <c:v> 6/17</c:v>
                </c:pt>
                <c:pt idx="134">
                  <c:v> 6/18</c:v>
                </c:pt>
                <c:pt idx="135">
                  <c:v> 6/19</c:v>
                </c:pt>
                <c:pt idx="136">
                  <c:v> 6/20</c:v>
                </c:pt>
                <c:pt idx="137">
                  <c:v> 6/21</c:v>
                </c:pt>
                <c:pt idx="138">
                  <c:v> 6/22</c:v>
                </c:pt>
                <c:pt idx="139">
                  <c:v> 6/23</c:v>
                </c:pt>
                <c:pt idx="140">
                  <c:v> 6/24</c:v>
                </c:pt>
                <c:pt idx="141">
                  <c:v> 6/25</c:v>
                </c:pt>
                <c:pt idx="142">
                  <c:v> 6/26</c:v>
                </c:pt>
                <c:pt idx="143">
                  <c:v> 6/27</c:v>
                </c:pt>
                <c:pt idx="144">
                  <c:v> 6/28</c:v>
                </c:pt>
                <c:pt idx="145">
                  <c:v> 6/29</c:v>
                </c:pt>
                <c:pt idx="146">
                  <c:v> 6/30</c:v>
                </c:pt>
                <c:pt idx="147">
                  <c:v> 7/1</c:v>
                </c:pt>
                <c:pt idx="148">
                  <c:v> 7/2</c:v>
                </c:pt>
                <c:pt idx="149">
                  <c:v> 7/3</c:v>
                </c:pt>
                <c:pt idx="150">
                  <c:v> 7/4</c:v>
                </c:pt>
                <c:pt idx="151">
                  <c:v> 7/5</c:v>
                </c:pt>
                <c:pt idx="152">
                  <c:v> 7/6</c:v>
                </c:pt>
                <c:pt idx="153">
                  <c:v> 7/7</c:v>
                </c:pt>
                <c:pt idx="154">
                  <c:v> 7/8</c:v>
                </c:pt>
                <c:pt idx="155">
                  <c:v> 7/9</c:v>
                </c:pt>
                <c:pt idx="156">
                  <c:v> 7/10</c:v>
                </c:pt>
                <c:pt idx="157">
                  <c:v> 7/11</c:v>
                </c:pt>
                <c:pt idx="158">
                  <c:v> 7/12</c:v>
                </c:pt>
                <c:pt idx="159">
                  <c:v> 7/13</c:v>
                </c:pt>
                <c:pt idx="160">
                  <c:v> 7/14</c:v>
                </c:pt>
                <c:pt idx="161">
                  <c:v> 7/15</c:v>
                </c:pt>
                <c:pt idx="162">
                  <c:v> 7/16</c:v>
                </c:pt>
                <c:pt idx="163">
                  <c:v> 7/17</c:v>
                </c:pt>
                <c:pt idx="164">
                  <c:v> 7/18</c:v>
                </c:pt>
                <c:pt idx="165">
                  <c:v> 7/19</c:v>
                </c:pt>
                <c:pt idx="166">
                  <c:v> 7/20</c:v>
                </c:pt>
                <c:pt idx="167">
                  <c:v> 7/21</c:v>
                </c:pt>
                <c:pt idx="168">
                  <c:v> 7/22</c:v>
                </c:pt>
                <c:pt idx="169">
                  <c:v> 7/23</c:v>
                </c:pt>
                <c:pt idx="170">
                  <c:v> 7/24</c:v>
                </c:pt>
                <c:pt idx="171">
                  <c:v> 7/25</c:v>
                </c:pt>
                <c:pt idx="172">
                  <c:v> 7/26</c:v>
                </c:pt>
                <c:pt idx="173">
                  <c:v> 7/27</c:v>
                </c:pt>
                <c:pt idx="174">
                  <c:v> 7/28</c:v>
                </c:pt>
                <c:pt idx="175">
                  <c:v> 7/29</c:v>
                </c:pt>
                <c:pt idx="176">
                  <c:v> 7/30</c:v>
                </c:pt>
                <c:pt idx="177">
                  <c:v> 7/31</c:v>
                </c:pt>
                <c:pt idx="178">
                  <c:v> 8/1</c:v>
                </c:pt>
                <c:pt idx="179">
                  <c:v> 8/2</c:v>
                </c:pt>
                <c:pt idx="180">
                  <c:v> 8/3</c:v>
                </c:pt>
                <c:pt idx="181">
                  <c:v> 8/4</c:v>
                </c:pt>
                <c:pt idx="182">
                  <c:v> 8/5</c:v>
                </c:pt>
                <c:pt idx="183">
                  <c:v> 8/6</c:v>
                </c:pt>
                <c:pt idx="184">
                  <c:v> 8/7</c:v>
                </c:pt>
                <c:pt idx="185">
                  <c:v> 8/8</c:v>
                </c:pt>
                <c:pt idx="186">
                  <c:v> 8/9</c:v>
                </c:pt>
                <c:pt idx="187">
                  <c:v> 8/10</c:v>
                </c:pt>
                <c:pt idx="188">
                  <c:v> 8/11</c:v>
                </c:pt>
                <c:pt idx="189">
                  <c:v> 8/12</c:v>
                </c:pt>
                <c:pt idx="190">
                  <c:v> 8/13</c:v>
                </c:pt>
                <c:pt idx="191">
                  <c:v> 8/14</c:v>
                </c:pt>
                <c:pt idx="192">
                  <c:v> 8/15</c:v>
                </c:pt>
                <c:pt idx="193">
                  <c:v> 8/16</c:v>
                </c:pt>
                <c:pt idx="194">
                  <c:v> 8/17</c:v>
                </c:pt>
                <c:pt idx="195">
                  <c:v> 8/18</c:v>
                </c:pt>
                <c:pt idx="196">
                  <c:v> 8/19</c:v>
                </c:pt>
                <c:pt idx="197">
                  <c:v> 8/20</c:v>
                </c:pt>
                <c:pt idx="198">
                  <c:v> 8/21</c:v>
                </c:pt>
                <c:pt idx="199">
                  <c:v> 8/22</c:v>
                </c:pt>
                <c:pt idx="200">
                  <c:v> 8/23</c:v>
                </c:pt>
                <c:pt idx="201">
                  <c:v> 8/24</c:v>
                </c:pt>
                <c:pt idx="202">
                  <c:v> 8/25</c:v>
                </c:pt>
                <c:pt idx="203">
                  <c:v> 8/26</c:v>
                </c:pt>
                <c:pt idx="204">
                  <c:v> 8/27</c:v>
                </c:pt>
                <c:pt idx="205">
                  <c:v> 8/28</c:v>
                </c:pt>
                <c:pt idx="206">
                  <c:v> 8/29</c:v>
                </c:pt>
                <c:pt idx="207">
                  <c:v> 8/30</c:v>
                </c:pt>
                <c:pt idx="208">
                  <c:v> 8/31</c:v>
                </c:pt>
                <c:pt idx="209">
                  <c:v> 9/1</c:v>
                </c:pt>
                <c:pt idx="210">
                  <c:v> 9/2</c:v>
                </c:pt>
                <c:pt idx="211">
                  <c:v> 9/3</c:v>
                </c:pt>
                <c:pt idx="212">
                  <c:v> 9/4</c:v>
                </c:pt>
                <c:pt idx="213">
                  <c:v> 9/5</c:v>
                </c:pt>
                <c:pt idx="214">
                  <c:v> 9/6</c:v>
                </c:pt>
                <c:pt idx="215">
                  <c:v> 9/7</c:v>
                </c:pt>
                <c:pt idx="216">
                  <c:v> 9/8</c:v>
                </c:pt>
                <c:pt idx="217">
                  <c:v> 9/9</c:v>
                </c:pt>
                <c:pt idx="218">
                  <c:v> 9/10</c:v>
                </c:pt>
                <c:pt idx="219">
                  <c:v> 9/11</c:v>
                </c:pt>
                <c:pt idx="220">
                  <c:v> 9/12</c:v>
                </c:pt>
                <c:pt idx="221">
                  <c:v> 9/13</c:v>
                </c:pt>
                <c:pt idx="222">
                  <c:v> 9/14</c:v>
                </c:pt>
                <c:pt idx="223">
                  <c:v> 9/15</c:v>
                </c:pt>
                <c:pt idx="224">
                  <c:v> 9/16</c:v>
                </c:pt>
                <c:pt idx="225">
                  <c:v> 9/17</c:v>
                </c:pt>
                <c:pt idx="226">
                  <c:v> 9/18</c:v>
                </c:pt>
                <c:pt idx="227">
                  <c:v> 9/19</c:v>
                </c:pt>
                <c:pt idx="228">
                  <c:v> 9/20</c:v>
                </c:pt>
                <c:pt idx="229">
                  <c:v> 9/21</c:v>
                </c:pt>
                <c:pt idx="230">
                  <c:v> 9/22</c:v>
                </c:pt>
                <c:pt idx="231">
                  <c:v> 9/23</c:v>
                </c:pt>
                <c:pt idx="232">
                  <c:v> 9/24</c:v>
                </c:pt>
                <c:pt idx="233">
                  <c:v> 9/25</c:v>
                </c:pt>
                <c:pt idx="234">
                  <c:v> 9/26</c:v>
                </c:pt>
                <c:pt idx="235">
                  <c:v> 9/27</c:v>
                </c:pt>
                <c:pt idx="236">
                  <c:v> 9/28</c:v>
                </c:pt>
                <c:pt idx="237">
                  <c:v> 9/29</c:v>
                </c:pt>
                <c:pt idx="238">
                  <c:v> 9/30</c:v>
                </c:pt>
                <c:pt idx="239">
                  <c:v> 10/1</c:v>
                </c:pt>
                <c:pt idx="240">
                  <c:v> 10/2</c:v>
                </c:pt>
                <c:pt idx="241">
                  <c:v> 10/3</c:v>
                </c:pt>
                <c:pt idx="242">
                  <c:v> 10/4</c:v>
                </c:pt>
                <c:pt idx="243">
                  <c:v> 10/5</c:v>
                </c:pt>
                <c:pt idx="244">
                  <c:v> 10/6</c:v>
                </c:pt>
                <c:pt idx="245">
                  <c:v> 10/7</c:v>
                </c:pt>
                <c:pt idx="246">
                  <c:v> 10/8</c:v>
                </c:pt>
                <c:pt idx="247">
                  <c:v> 10/9</c:v>
                </c:pt>
                <c:pt idx="248">
                  <c:v> 10/10</c:v>
                </c:pt>
                <c:pt idx="249">
                  <c:v> 10/11</c:v>
                </c:pt>
                <c:pt idx="250">
                  <c:v> 10/12</c:v>
                </c:pt>
                <c:pt idx="251">
                  <c:v> 10/13</c:v>
                </c:pt>
                <c:pt idx="252">
                  <c:v> 10/14</c:v>
                </c:pt>
                <c:pt idx="253">
                  <c:v> 10/15</c:v>
                </c:pt>
                <c:pt idx="254">
                  <c:v> 10/16</c:v>
                </c:pt>
                <c:pt idx="255">
                  <c:v> 10/17</c:v>
                </c:pt>
                <c:pt idx="256">
                  <c:v> 10/18</c:v>
                </c:pt>
                <c:pt idx="257">
                  <c:v> 10/19</c:v>
                </c:pt>
                <c:pt idx="258">
                  <c:v> 10/20</c:v>
                </c:pt>
                <c:pt idx="259">
                  <c:v> 10/21</c:v>
                </c:pt>
                <c:pt idx="260">
                  <c:v> 10/22</c:v>
                </c:pt>
                <c:pt idx="261">
                  <c:v> 10/23</c:v>
                </c:pt>
                <c:pt idx="262">
                  <c:v> 10/24</c:v>
                </c:pt>
                <c:pt idx="263">
                  <c:v> 10/25</c:v>
                </c:pt>
                <c:pt idx="264">
                  <c:v> 10/26</c:v>
                </c:pt>
                <c:pt idx="265">
                  <c:v> 10/27</c:v>
                </c:pt>
                <c:pt idx="266">
                  <c:v> 10/28</c:v>
                </c:pt>
                <c:pt idx="267">
                  <c:v> 10/29</c:v>
                </c:pt>
                <c:pt idx="268">
                  <c:v> 10/30</c:v>
                </c:pt>
                <c:pt idx="269">
                  <c:v> 10/31</c:v>
                </c:pt>
                <c:pt idx="270">
                  <c:v> 11/1</c:v>
                </c:pt>
                <c:pt idx="271">
                  <c:v> 11/2</c:v>
                </c:pt>
                <c:pt idx="272">
                  <c:v> 11/3</c:v>
                </c:pt>
                <c:pt idx="273">
                  <c:v> 11/4</c:v>
                </c:pt>
                <c:pt idx="274">
                  <c:v> 11/5</c:v>
                </c:pt>
                <c:pt idx="275">
                  <c:v> 11/6</c:v>
                </c:pt>
                <c:pt idx="276">
                  <c:v> 11/7</c:v>
                </c:pt>
                <c:pt idx="277">
                  <c:v> 11/8</c:v>
                </c:pt>
                <c:pt idx="278">
                  <c:v> 11/9</c:v>
                </c:pt>
                <c:pt idx="279">
                  <c:v> 11/10</c:v>
                </c:pt>
                <c:pt idx="280">
                  <c:v> 11/11</c:v>
                </c:pt>
                <c:pt idx="281">
                  <c:v> 11/12</c:v>
                </c:pt>
                <c:pt idx="282">
                  <c:v> 11/13</c:v>
                </c:pt>
                <c:pt idx="283">
                  <c:v> 11/14</c:v>
                </c:pt>
                <c:pt idx="284">
                  <c:v> 11/15</c:v>
                </c:pt>
                <c:pt idx="285">
                  <c:v> 11/16</c:v>
                </c:pt>
                <c:pt idx="286">
                  <c:v> 11/17</c:v>
                </c:pt>
                <c:pt idx="287">
                  <c:v> 11/18</c:v>
                </c:pt>
                <c:pt idx="288">
                  <c:v> 11/19</c:v>
                </c:pt>
                <c:pt idx="289">
                  <c:v> 11/20</c:v>
                </c:pt>
                <c:pt idx="290">
                  <c:v> 11/21</c:v>
                </c:pt>
                <c:pt idx="291">
                  <c:v> 11/22</c:v>
                </c:pt>
                <c:pt idx="292">
                  <c:v> 11/23</c:v>
                </c:pt>
                <c:pt idx="293">
                  <c:v> 11/24</c:v>
                </c:pt>
                <c:pt idx="294">
                  <c:v> 11/25</c:v>
                </c:pt>
                <c:pt idx="295">
                  <c:v> 11/26</c:v>
                </c:pt>
                <c:pt idx="296">
                  <c:v> 11/27</c:v>
                </c:pt>
                <c:pt idx="297">
                  <c:v> 11/28</c:v>
                </c:pt>
                <c:pt idx="298">
                  <c:v> 11/29</c:v>
                </c:pt>
                <c:pt idx="299">
                  <c:v> 11/30</c:v>
                </c:pt>
              </c:strCache>
            </c:strRef>
          </c:cat>
          <c:val>
            <c:numRef>
              <c:f>pcr_positive_daily!$B$2:$B$301</c:f>
              <c:numCache>
                <c:formatCode>General</c:formatCode>
                <c:ptCount val="300"/>
                <c:pt idx="0">
                  <c:v>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1</c:v>
                </c:pt>
                <c:pt idx="8">
                  <c:v>4</c:v>
                </c:pt>
                <c:pt idx="9">
                  <c:v>7</c:v>
                </c:pt>
                <c:pt idx="10">
                  <c:v>12</c:v>
                </c:pt>
                <c:pt idx="11">
                  <c:v>6</c:v>
                </c:pt>
                <c:pt idx="12">
                  <c:v>7</c:v>
                </c:pt>
                <c:pt idx="13">
                  <c:v>7</c:v>
                </c:pt>
                <c:pt idx="14">
                  <c:v>10</c:v>
                </c:pt>
                <c:pt idx="15">
                  <c:v>9</c:v>
                </c:pt>
                <c:pt idx="16">
                  <c:v>11</c:v>
                </c:pt>
                <c:pt idx="17">
                  <c:v>27</c:v>
                </c:pt>
                <c:pt idx="18">
                  <c:v>12</c:v>
                </c:pt>
                <c:pt idx="19">
                  <c:v>12</c:v>
                </c:pt>
                <c:pt idx="20">
                  <c:v>8</c:v>
                </c:pt>
                <c:pt idx="21">
                  <c:v>22</c:v>
                </c:pt>
                <c:pt idx="22">
                  <c:v>24</c:v>
                </c:pt>
                <c:pt idx="23">
                  <c:v>20</c:v>
                </c:pt>
                <c:pt idx="24">
                  <c:v>9</c:v>
                </c:pt>
                <c:pt idx="25">
                  <c:v>15</c:v>
                </c:pt>
                <c:pt idx="26">
                  <c:v>14</c:v>
                </c:pt>
                <c:pt idx="27">
                  <c:v>16</c:v>
                </c:pt>
                <c:pt idx="28">
                  <c:v>33</c:v>
                </c:pt>
                <c:pt idx="29">
                  <c:v>31</c:v>
                </c:pt>
                <c:pt idx="30">
                  <c:v>59</c:v>
                </c:pt>
                <c:pt idx="31">
                  <c:v>47</c:v>
                </c:pt>
                <c:pt idx="32">
                  <c:v>33</c:v>
                </c:pt>
                <c:pt idx="33">
                  <c:v>26</c:v>
                </c:pt>
                <c:pt idx="34">
                  <c:v>54</c:v>
                </c:pt>
                <c:pt idx="35">
                  <c:v>52</c:v>
                </c:pt>
                <c:pt idx="36">
                  <c:v>55</c:v>
                </c:pt>
                <c:pt idx="37">
                  <c:v>40</c:v>
                </c:pt>
                <c:pt idx="38">
                  <c:v>62</c:v>
                </c:pt>
                <c:pt idx="39">
                  <c:v>33</c:v>
                </c:pt>
                <c:pt idx="40">
                  <c:v>15</c:v>
                </c:pt>
                <c:pt idx="41">
                  <c:v>44</c:v>
                </c:pt>
                <c:pt idx="42">
                  <c:v>39</c:v>
                </c:pt>
                <c:pt idx="43">
                  <c:v>36</c:v>
                </c:pt>
                <c:pt idx="44">
                  <c:v>53</c:v>
                </c:pt>
                <c:pt idx="45">
                  <c:v>34</c:v>
                </c:pt>
                <c:pt idx="46">
                  <c:v>42</c:v>
                </c:pt>
                <c:pt idx="47">
                  <c:v>38</c:v>
                </c:pt>
                <c:pt idx="48">
                  <c:v>65</c:v>
                </c:pt>
                <c:pt idx="49">
                  <c:v>93</c:v>
                </c:pt>
                <c:pt idx="50">
                  <c:v>96</c:v>
                </c:pt>
                <c:pt idx="51">
                  <c:v>104</c:v>
                </c:pt>
                <c:pt idx="52">
                  <c:v>194</c:v>
                </c:pt>
                <c:pt idx="53">
                  <c:v>185</c:v>
                </c:pt>
                <c:pt idx="54">
                  <c:v>74</c:v>
                </c:pt>
                <c:pt idx="55">
                  <c:v>218</c:v>
                </c:pt>
                <c:pt idx="56">
                  <c:v>224</c:v>
                </c:pt>
                <c:pt idx="57">
                  <c:v>253</c:v>
                </c:pt>
                <c:pt idx="58">
                  <c:v>337</c:v>
                </c:pt>
                <c:pt idx="59">
                  <c:v>370</c:v>
                </c:pt>
                <c:pt idx="60">
                  <c:v>386</c:v>
                </c:pt>
                <c:pt idx="61">
                  <c:v>270</c:v>
                </c:pt>
                <c:pt idx="62">
                  <c:v>377</c:v>
                </c:pt>
                <c:pt idx="63">
                  <c:v>550</c:v>
                </c:pt>
                <c:pt idx="64">
                  <c:v>572</c:v>
                </c:pt>
                <c:pt idx="65">
                  <c:v>708</c:v>
                </c:pt>
                <c:pt idx="66">
                  <c:v>676</c:v>
                </c:pt>
                <c:pt idx="67">
                  <c:v>571</c:v>
                </c:pt>
                <c:pt idx="68">
                  <c:v>333</c:v>
                </c:pt>
                <c:pt idx="69">
                  <c:v>511</c:v>
                </c:pt>
                <c:pt idx="70">
                  <c:v>511</c:v>
                </c:pt>
                <c:pt idx="71">
                  <c:v>596</c:v>
                </c:pt>
                <c:pt idx="72">
                  <c:v>575</c:v>
                </c:pt>
                <c:pt idx="73">
                  <c:v>590</c:v>
                </c:pt>
                <c:pt idx="74">
                  <c:v>372</c:v>
                </c:pt>
                <c:pt idx="75">
                  <c:v>365</c:v>
                </c:pt>
                <c:pt idx="76">
                  <c:v>374</c:v>
                </c:pt>
                <c:pt idx="77">
                  <c:v>450</c:v>
                </c:pt>
                <c:pt idx="78">
                  <c:v>445</c:v>
                </c:pt>
                <c:pt idx="79">
                  <c:v>451</c:v>
                </c:pt>
                <c:pt idx="80">
                  <c:v>374</c:v>
                </c:pt>
                <c:pt idx="81">
                  <c:v>221</c:v>
                </c:pt>
                <c:pt idx="82">
                  <c:v>189</c:v>
                </c:pt>
                <c:pt idx="83">
                  <c:v>284</c:v>
                </c:pt>
                <c:pt idx="84">
                  <c:v>227</c:v>
                </c:pt>
                <c:pt idx="85">
                  <c:v>199</c:v>
                </c:pt>
                <c:pt idx="86">
                  <c:v>266</c:v>
                </c:pt>
                <c:pt idx="87">
                  <c:v>302</c:v>
                </c:pt>
                <c:pt idx="88">
                  <c:v>204</c:v>
                </c:pt>
                <c:pt idx="89">
                  <c:v>177</c:v>
                </c:pt>
                <c:pt idx="90">
                  <c:v>120</c:v>
                </c:pt>
                <c:pt idx="91">
                  <c:v>106</c:v>
                </c:pt>
                <c:pt idx="92">
                  <c:v>96</c:v>
                </c:pt>
                <c:pt idx="93">
                  <c:v>89</c:v>
                </c:pt>
                <c:pt idx="94">
                  <c:v>108</c:v>
                </c:pt>
                <c:pt idx="95">
                  <c:v>68</c:v>
                </c:pt>
                <c:pt idx="96">
                  <c:v>50</c:v>
                </c:pt>
                <c:pt idx="97">
                  <c:v>80</c:v>
                </c:pt>
                <c:pt idx="98">
                  <c:v>54</c:v>
                </c:pt>
                <c:pt idx="99">
                  <c:v>100</c:v>
                </c:pt>
                <c:pt idx="100">
                  <c:v>52</c:v>
                </c:pt>
                <c:pt idx="101">
                  <c:v>57</c:v>
                </c:pt>
                <c:pt idx="102">
                  <c:v>30</c:v>
                </c:pt>
                <c:pt idx="103">
                  <c:v>30</c:v>
                </c:pt>
                <c:pt idx="104">
                  <c:v>31</c:v>
                </c:pt>
                <c:pt idx="105">
                  <c:v>38</c:v>
                </c:pt>
                <c:pt idx="106">
                  <c:v>43</c:v>
                </c:pt>
                <c:pt idx="107">
                  <c:v>31</c:v>
                </c:pt>
                <c:pt idx="108">
                  <c:v>29</c:v>
                </c:pt>
                <c:pt idx="109">
                  <c:v>40</c:v>
                </c:pt>
                <c:pt idx="110">
                  <c:v>20</c:v>
                </c:pt>
                <c:pt idx="111">
                  <c:v>27</c:v>
                </c:pt>
                <c:pt idx="112">
                  <c:v>37</c:v>
                </c:pt>
                <c:pt idx="113">
                  <c:v>61</c:v>
                </c:pt>
                <c:pt idx="114">
                  <c:v>64</c:v>
                </c:pt>
                <c:pt idx="115">
                  <c:v>46</c:v>
                </c:pt>
                <c:pt idx="116">
                  <c:v>32</c:v>
                </c:pt>
                <c:pt idx="117">
                  <c:v>36</c:v>
                </c:pt>
                <c:pt idx="118">
                  <c:v>51</c:v>
                </c:pt>
                <c:pt idx="119">
                  <c:v>26</c:v>
                </c:pt>
                <c:pt idx="120">
                  <c:v>45</c:v>
                </c:pt>
                <c:pt idx="121">
                  <c:v>41</c:v>
                </c:pt>
                <c:pt idx="122">
                  <c:v>45</c:v>
                </c:pt>
                <c:pt idx="123">
                  <c:v>32</c:v>
                </c:pt>
                <c:pt idx="124">
                  <c:v>22</c:v>
                </c:pt>
                <c:pt idx="125">
                  <c:v>30</c:v>
                </c:pt>
                <c:pt idx="126">
                  <c:v>36</c:v>
                </c:pt>
                <c:pt idx="127">
                  <c:v>40</c:v>
                </c:pt>
                <c:pt idx="128">
                  <c:v>57</c:v>
                </c:pt>
                <c:pt idx="129">
                  <c:v>43</c:v>
                </c:pt>
                <c:pt idx="130">
                  <c:v>62</c:v>
                </c:pt>
                <c:pt idx="131">
                  <c:v>60</c:v>
                </c:pt>
                <c:pt idx="132">
                  <c:v>42</c:v>
                </c:pt>
                <c:pt idx="133">
                  <c:v>43</c:v>
                </c:pt>
                <c:pt idx="134">
                  <c:v>68</c:v>
                </c:pt>
                <c:pt idx="135">
                  <c:v>54</c:v>
                </c:pt>
                <c:pt idx="136">
                  <c:v>65</c:v>
                </c:pt>
                <c:pt idx="137">
                  <c:v>49</c:v>
                </c:pt>
                <c:pt idx="138">
                  <c:v>40</c:v>
                </c:pt>
                <c:pt idx="139">
                  <c:v>53</c:v>
                </c:pt>
                <c:pt idx="140">
                  <c:v>89</c:v>
                </c:pt>
                <c:pt idx="141">
                  <c:v>79</c:v>
                </c:pt>
                <c:pt idx="142">
                  <c:v>99</c:v>
                </c:pt>
                <c:pt idx="143">
                  <c:v>88</c:v>
                </c:pt>
                <c:pt idx="144">
                  <c:v>111</c:v>
                </c:pt>
                <c:pt idx="145">
                  <c:v>110</c:v>
                </c:pt>
                <c:pt idx="146">
                  <c:v>132</c:v>
                </c:pt>
                <c:pt idx="147">
                  <c:v>125</c:v>
                </c:pt>
                <c:pt idx="148">
                  <c:v>194</c:v>
                </c:pt>
                <c:pt idx="149">
                  <c:v>249</c:v>
                </c:pt>
                <c:pt idx="150">
                  <c:v>268</c:v>
                </c:pt>
                <c:pt idx="151">
                  <c:v>195</c:v>
                </c:pt>
                <c:pt idx="152">
                  <c:v>172</c:v>
                </c:pt>
                <c:pt idx="153">
                  <c:v>208</c:v>
                </c:pt>
                <c:pt idx="154">
                  <c:v>203</c:v>
                </c:pt>
                <c:pt idx="155">
                  <c:v>352</c:v>
                </c:pt>
                <c:pt idx="156">
                  <c:v>420</c:v>
                </c:pt>
                <c:pt idx="157">
                  <c:v>373</c:v>
                </c:pt>
                <c:pt idx="158">
                  <c:v>391</c:v>
                </c:pt>
                <c:pt idx="159">
                  <c:v>248</c:v>
                </c:pt>
                <c:pt idx="160">
                  <c:v>327</c:v>
                </c:pt>
                <c:pt idx="161">
                  <c:v>440</c:v>
                </c:pt>
                <c:pt idx="162">
                  <c:v>619</c:v>
                </c:pt>
                <c:pt idx="163">
                  <c:v>588</c:v>
                </c:pt>
                <c:pt idx="164">
                  <c:v>655</c:v>
                </c:pt>
                <c:pt idx="165">
                  <c:v>501</c:v>
                </c:pt>
                <c:pt idx="166">
                  <c:v>407</c:v>
                </c:pt>
                <c:pt idx="167">
                  <c:v>618</c:v>
                </c:pt>
                <c:pt idx="168">
                  <c:v>792</c:v>
                </c:pt>
                <c:pt idx="169">
                  <c:v>966</c:v>
                </c:pt>
                <c:pt idx="170">
                  <c:v>766</c:v>
                </c:pt>
                <c:pt idx="171">
                  <c:v>798</c:v>
                </c:pt>
                <c:pt idx="172">
                  <c:v>830</c:v>
                </c:pt>
                <c:pt idx="173">
                  <c:v>581</c:v>
                </c:pt>
                <c:pt idx="174">
                  <c:v>968</c:v>
                </c:pt>
                <c:pt idx="175">
                  <c:v>1242</c:v>
                </c:pt>
                <c:pt idx="176">
                  <c:v>1297</c:v>
                </c:pt>
                <c:pt idx="177">
                  <c:v>1574</c:v>
                </c:pt>
                <c:pt idx="178">
                  <c:v>1535</c:v>
                </c:pt>
                <c:pt idx="179">
                  <c:v>1324</c:v>
                </c:pt>
                <c:pt idx="180">
                  <c:v>937</c:v>
                </c:pt>
                <c:pt idx="181">
                  <c:v>1234</c:v>
                </c:pt>
                <c:pt idx="182">
                  <c:v>1350</c:v>
                </c:pt>
                <c:pt idx="183">
                  <c:v>1479</c:v>
                </c:pt>
                <c:pt idx="184">
                  <c:v>1595</c:v>
                </c:pt>
                <c:pt idx="185">
                  <c:v>1523</c:v>
                </c:pt>
                <c:pt idx="186">
                  <c:v>1486</c:v>
                </c:pt>
                <c:pt idx="187">
                  <c:v>836</c:v>
                </c:pt>
                <c:pt idx="188">
                  <c:v>693</c:v>
                </c:pt>
                <c:pt idx="189">
                  <c:v>969</c:v>
                </c:pt>
                <c:pt idx="190">
                  <c:v>1176</c:v>
                </c:pt>
                <c:pt idx="191">
                  <c:v>1356</c:v>
                </c:pt>
                <c:pt idx="192">
                  <c:v>1234</c:v>
                </c:pt>
                <c:pt idx="193">
                  <c:v>1017</c:v>
                </c:pt>
                <c:pt idx="194">
                  <c:v>630</c:v>
                </c:pt>
                <c:pt idx="195">
                  <c:v>904</c:v>
                </c:pt>
                <c:pt idx="196">
                  <c:v>1080</c:v>
                </c:pt>
                <c:pt idx="197">
                  <c:v>1182</c:v>
                </c:pt>
                <c:pt idx="198">
                  <c:v>1036</c:v>
                </c:pt>
                <c:pt idx="199">
                  <c:v>985</c:v>
                </c:pt>
                <c:pt idx="200">
                  <c:v>739</c:v>
                </c:pt>
                <c:pt idx="201">
                  <c:v>491</c:v>
                </c:pt>
                <c:pt idx="202">
                  <c:v>712</c:v>
                </c:pt>
                <c:pt idx="203">
                  <c:v>893</c:v>
                </c:pt>
                <c:pt idx="204">
                  <c:v>867</c:v>
                </c:pt>
                <c:pt idx="205">
                  <c:v>870</c:v>
                </c:pt>
                <c:pt idx="206">
                  <c:v>844</c:v>
                </c:pt>
                <c:pt idx="207">
                  <c:v>598</c:v>
                </c:pt>
                <c:pt idx="208">
                  <c:v>425</c:v>
                </c:pt>
                <c:pt idx="209">
                  <c:v>624</c:v>
                </c:pt>
                <c:pt idx="210">
                  <c:v>589</c:v>
                </c:pt>
                <c:pt idx="211">
                  <c:v>656</c:v>
                </c:pt>
                <c:pt idx="212">
                  <c:v>583</c:v>
                </c:pt>
                <c:pt idx="213">
                  <c:v>598</c:v>
                </c:pt>
                <c:pt idx="214">
                  <c:v>447</c:v>
                </c:pt>
                <c:pt idx="215">
                  <c:v>288</c:v>
                </c:pt>
                <c:pt idx="216">
                  <c:v>514</c:v>
                </c:pt>
                <c:pt idx="217">
                  <c:v>507</c:v>
                </c:pt>
                <c:pt idx="218">
                  <c:v>709</c:v>
                </c:pt>
                <c:pt idx="219">
                  <c:v>639</c:v>
                </c:pt>
                <c:pt idx="220">
                  <c:v>641</c:v>
                </c:pt>
                <c:pt idx="221">
                  <c:v>439</c:v>
                </c:pt>
                <c:pt idx="222">
                  <c:v>265</c:v>
                </c:pt>
                <c:pt idx="223">
                  <c:v>531</c:v>
                </c:pt>
                <c:pt idx="224">
                  <c:v>543</c:v>
                </c:pt>
                <c:pt idx="225">
                  <c:v>480</c:v>
                </c:pt>
                <c:pt idx="226">
                  <c:v>569</c:v>
                </c:pt>
                <c:pt idx="227">
                  <c:v>597</c:v>
                </c:pt>
                <c:pt idx="228">
                  <c:v>469</c:v>
                </c:pt>
                <c:pt idx="229">
                  <c:v>307</c:v>
                </c:pt>
                <c:pt idx="230">
                  <c:v>322</c:v>
                </c:pt>
                <c:pt idx="231">
                  <c:v>216</c:v>
                </c:pt>
                <c:pt idx="232">
                  <c:v>477</c:v>
                </c:pt>
                <c:pt idx="233">
                  <c:v>570</c:v>
                </c:pt>
                <c:pt idx="234">
                  <c:v>638</c:v>
                </c:pt>
                <c:pt idx="235">
                  <c:v>478</c:v>
                </c:pt>
                <c:pt idx="236">
                  <c:v>294</c:v>
                </c:pt>
                <c:pt idx="237">
                  <c:v>531</c:v>
                </c:pt>
                <c:pt idx="238">
                  <c:v>570</c:v>
                </c:pt>
                <c:pt idx="239">
                  <c:v>623</c:v>
                </c:pt>
                <c:pt idx="240">
                  <c:v>537</c:v>
                </c:pt>
                <c:pt idx="241">
                  <c:v>564</c:v>
                </c:pt>
                <c:pt idx="242">
                  <c:v>395</c:v>
                </c:pt>
                <c:pt idx="243">
                  <c:v>271</c:v>
                </c:pt>
                <c:pt idx="244">
                  <c:v>497</c:v>
                </c:pt>
                <c:pt idx="245">
                  <c:v>505</c:v>
                </c:pt>
                <c:pt idx="246">
                  <c:v>622</c:v>
                </c:pt>
                <c:pt idx="247">
                  <c:v>594</c:v>
                </c:pt>
                <c:pt idx="248">
                  <c:v>669</c:v>
                </c:pt>
                <c:pt idx="249">
                  <c:v>432</c:v>
                </c:pt>
                <c:pt idx="250">
                  <c:v>273</c:v>
                </c:pt>
                <c:pt idx="251">
                  <c:v>494</c:v>
                </c:pt>
                <c:pt idx="252">
                  <c:v>549</c:v>
                </c:pt>
                <c:pt idx="253">
                  <c:v>703</c:v>
                </c:pt>
                <c:pt idx="254">
                  <c:v>635</c:v>
                </c:pt>
                <c:pt idx="255">
                  <c:v>579</c:v>
                </c:pt>
                <c:pt idx="256">
                  <c:v>457</c:v>
                </c:pt>
                <c:pt idx="257">
                  <c:v>315</c:v>
                </c:pt>
                <c:pt idx="258">
                  <c:v>477</c:v>
                </c:pt>
                <c:pt idx="259">
                  <c:v>616</c:v>
                </c:pt>
                <c:pt idx="260">
                  <c:v>610</c:v>
                </c:pt>
                <c:pt idx="261">
                  <c:v>745</c:v>
                </c:pt>
                <c:pt idx="262">
                  <c:v>718</c:v>
                </c:pt>
                <c:pt idx="263">
                  <c:v>488</c:v>
                </c:pt>
                <c:pt idx="264">
                  <c:v>401</c:v>
                </c:pt>
                <c:pt idx="265">
                  <c:v>649</c:v>
                </c:pt>
                <c:pt idx="266">
                  <c:v>724</c:v>
                </c:pt>
                <c:pt idx="267">
                  <c:v>804</c:v>
                </c:pt>
                <c:pt idx="268">
                  <c:v>769</c:v>
                </c:pt>
                <c:pt idx="269">
                  <c:v>868</c:v>
                </c:pt>
                <c:pt idx="270">
                  <c:v>606</c:v>
                </c:pt>
                <c:pt idx="271">
                  <c:v>482</c:v>
                </c:pt>
                <c:pt idx="272">
                  <c:v>868</c:v>
                </c:pt>
                <c:pt idx="273">
                  <c:v>607</c:v>
                </c:pt>
                <c:pt idx="274">
                  <c:v>1049</c:v>
                </c:pt>
                <c:pt idx="275">
                  <c:v>1137</c:v>
                </c:pt>
                <c:pt idx="276">
                  <c:v>1302</c:v>
                </c:pt>
                <c:pt idx="277">
                  <c:v>938</c:v>
                </c:pt>
                <c:pt idx="278">
                  <c:v>772</c:v>
                </c:pt>
                <c:pt idx="279">
                  <c:v>1278</c:v>
                </c:pt>
                <c:pt idx="280">
                  <c:v>1535</c:v>
                </c:pt>
                <c:pt idx="281">
                  <c:v>1623</c:v>
                </c:pt>
                <c:pt idx="282">
                  <c:v>1704</c:v>
                </c:pt>
                <c:pt idx="283">
                  <c:v>1723</c:v>
                </c:pt>
                <c:pt idx="284">
                  <c:v>1423</c:v>
                </c:pt>
                <c:pt idx="285">
                  <c:v>948</c:v>
                </c:pt>
                <c:pt idx="286">
                  <c:v>1686</c:v>
                </c:pt>
                <c:pt idx="287">
                  <c:v>2179</c:v>
                </c:pt>
                <c:pt idx="288">
                  <c:v>2383</c:v>
                </c:pt>
                <c:pt idx="289">
                  <c:v>2418</c:v>
                </c:pt>
                <c:pt idx="290">
                  <c:v>2508</c:v>
                </c:pt>
                <c:pt idx="291">
                  <c:v>2150</c:v>
                </c:pt>
                <c:pt idx="292">
                  <c:v>1513</c:v>
                </c:pt>
                <c:pt idx="293">
                  <c:v>1217</c:v>
                </c:pt>
                <c:pt idx="294">
                  <c:v>1930</c:v>
                </c:pt>
                <c:pt idx="295">
                  <c:v>2499</c:v>
                </c:pt>
                <c:pt idx="296">
                  <c:v>2510</c:v>
                </c:pt>
                <c:pt idx="297">
                  <c:v>2674</c:v>
                </c:pt>
                <c:pt idx="298">
                  <c:v>2041</c:v>
                </c:pt>
                <c:pt idx="299">
                  <c:v>14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A5B-4F8C-9B47-98A123A3E96C}"/>
            </c:ext>
          </c:extLst>
        </c:ser>
        <c:ser>
          <c:idx val="1"/>
          <c:order val="1"/>
          <c:tx>
            <c:strRef>
              <c:f>pcr_positive_daily!$C$1</c:f>
              <c:strCache>
                <c:ptCount val="1"/>
                <c:pt idx="0">
                  <c:v>severe patients</c:v>
                </c:pt>
              </c:strCache>
            </c:strRef>
          </c:tx>
          <c:spPr>
            <a:solidFill>
              <a:schemeClr val="dk1">
                <a:tint val="55000"/>
              </a:schemeClr>
            </a:solidFill>
            <a:ln>
              <a:noFill/>
            </a:ln>
            <a:effectLst/>
          </c:spPr>
          <c:invertIfNegative val="0"/>
          <c:cat>
            <c:strRef>
              <c:f>pcr_positive_daily!$A$2:$A$301</c:f>
              <c:strCache>
                <c:ptCount val="300"/>
                <c:pt idx="0">
                  <c:v> 2/5</c:v>
                </c:pt>
                <c:pt idx="1">
                  <c:v> 2/6</c:v>
                </c:pt>
                <c:pt idx="2">
                  <c:v> 2/7</c:v>
                </c:pt>
                <c:pt idx="3">
                  <c:v> 2/8</c:v>
                </c:pt>
                <c:pt idx="4">
                  <c:v> 2/9</c:v>
                </c:pt>
                <c:pt idx="5">
                  <c:v> 2/10</c:v>
                </c:pt>
                <c:pt idx="6">
                  <c:v> 2/11</c:v>
                </c:pt>
                <c:pt idx="7">
                  <c:v> 2/12</c:v>
                </c:pt>
                <c:pt idx="8">
                  <c:v> 2/13</c:v>
                </c:pt>
                <c:pt idx="9">
                  <c:v> 2/14</c:v>
                </c:pt>
                <c:pt idx="10">
                  <c:v> 2/15</c:v>
                </c:pt>
                <c:pt idx="11">
                  <c:v> 2/16</c:v>
                </c:pt>
                <c:pt idx="12">
                  <c:v> 2/17</c:v>
                </c:pt>
                <c:pt idx="13">
                  <c:v> 2/18</c:v>
                </c:pt>
                <c:pt idx="14">
                  <c:v> 2/19</c:v>
                </c:pt>
                <c:pt idx="15">
                  <c:v> 2/20</c:v>
                </c:pt>
                <c:pt idx="16">
                  <c:v> 2/21</c:v>
                </c:pt>
                <c:pt idx="17">
                  <c:v> 2/22</c:v>
                </c:pt>
                <c:pt idx="18">
                  <c:v> 2/23</c:v>
                </c:pt>
                <c:pt idx="19">
                  <c:v> 2/24</c:v>
                </c:pt>
                <c:pt idx="20">
                  <c:v> 2/25</c:v>
                </c:pt>
                <c:pt idx="21">
                  <c:v> 2/26</c:v>
                </c:pt>
                <c:pt idx="22">
                  <c:v> 2/27</c:v>
                </c:pt>
                <c:pt idx="23">
                  <c:v> 2/28</c:v>
                </c:pt>
                <c:pt idx="24">
                  <c:v> 2/29</c:v>
                </c:pt>
                <c:pt idx="25">
                  <c:v> 3/1</c:v>
                </c:pt>
                <c:pt idx="26">
                  <c:v> 3/2</c:v>
                </c:pt>
                <c:pt idx="27">
                  <c:v> 3/3</c:v>
                </c:pt>
                <c:pt idx="28">
                  <c:v> 3/4</c:v>
                </c:pt>
                <c:pt idx="29">
                  <c:v> 3/5</c:v>
                </c:pt>
                <c:pt idx="30">
                  <c:v> 3/6</c:v>
                </c:pt>
                <c:pt idx="31">
                  <c:v> 3/7</c:v>
                </c:pt>
                <c:pt idx="32">
                  <c:v> 3/8</c:v>
                </c:pt>
                <c:pt idx="33">
                  <c:v> 3/9</c:v>
                </c:pt>
                <c:pt idx="34">
                  <c:v> 3/10</c:v>
                </c:pt>
                <c:pt idx="35">
                  <c:v> 3/11</c:v>
                </c:pt>
                <c:pt idx="36">
                  <c:v> 3/12</c:v>
                </c:pt>
                <c:pt idx="37">
                  <c:v> 3/13</c:v>
                </c:pt>
                <c:pt idx="38">
                  <c:v> 3/14</c:v>
                </c:pt>
                <c:pt idx="39">
                  <c:v> 3/15</c:v>
                </c:pt>
                <c:pt idx="40">
                  <c:v> 3/16</c:v>
                </c:pt>
                <c:pt idx="41">
                  <c:v> 3/17</c:v>
                </c:pt>
                <c:pt idx="42">
                  <c:v> 3/18</c:v>
                </c:pt>
                <c:pt idx="43">
                  <c:v> 3/19</c:v>
                </c:pt>
                <c:pt idx="44">
                  <c:v> 3/20</c:v>
                </c:pt>
                <c:pt idx="45">
                  <c:v> 3/21</c:v>
                </c:pt>
                <c:pt idx="46">
                  <c:v> 3/22</c:v>
                </c:pt>
                <c:pt idx="47">
                  <c:v> 3/23</c:v>
                </c:pt>
                <c:pt idx="48">
                  <c:v> 3/24</c:v>
                </c:pt>
                <c:pt idx="49">
                  <c:v> 3/25</c:v>
                </c:pt>
                <c:pt idx="50">
                  <c:v> 3/26</c:v>
                </c:pt>
                <c:pt idx="51">
                  <c:v> 3/27</c:v>
                </c:pt>
                <c:pt idx="52">
                  <c:v> 3/28</c:v>
                </c:pt>
                <c:pt idx="53">
                  <c:v> 3/29</c:v>
                </c:pt>
                <c:pt idx="54">
                  <c:v> 3/30</c:v>
                </c:pt>
                <c:pt idx="55">
                  <c:v> 3/31</c:v>
                </c:pt>
                <c:pt idx="56">
                  <c:v> 4/1</c:v>
                </c:pt>
                <c:pt idx="57">
                  <c:v> 4/2</c:v>
                </c:pt>
                <c:pt idx="58">
                  <c:v> 4/3</c:v>
                </c:pt>
                <c:pt idx="59">
                  <c:v> 4/4</c:v>
                </c:pt>
                <c:pt idx="60">
                  <c:v> 4/5</c:v>
                </c:pt>
                <c:pt idx="61">
                  <c:v> 4/6</c:v>
                </c:pt>
                <c:pt idx="62">
                  <c:v> 4/7</c:v>
                </c:pt>
                <c:pt idx="63">
                  <c:v> 4/8</c:v>
                </c:pt>
                <c:pt idx="64">
                  <c:v> 4/9</c:v>
                </c:pt>
                <c:pt idx="65">
                  <c:v> 4/10</c:v>
                </c:pt>
                <c:pt idx="66">
                  <c:v> 4/11</c:v>
                </c:pt>
                <c:pt idx="67">
                  <c:v> 4/12</c:v>
                </c:pt>
                <c:pt idx="68">
                  <c:v> 4/13</c:v>
                </c:pt>
                <c:pt idx="69">
                  <c:v> 4/14</c:v>
                </c:pt>
                <c:pt idx="70">
                  <c:v> 4/15</c:v>
                </c:pt>
                <c:pt idx="71">
                  <c:v> 4/16</c:v>
                </c:pt>
                <c:pt idx="72">
                  <c:v> 4/17</c:v>
                </c:pt>
                <c:pt idx="73">
                  <c:v> 4/18</c:v>
                </c:pt>
                <c:pt idx="74">
                  <c:v> 4/19</c:v>
                </c:pt>
                <c:pt idx="75">
                  <c:v> 4/20</c:v>
                </c:pt>
                <c:pt idx="76">
                  <c:v> 4/21</c:v>
                </c:pt>
                <c:pt idx="77">
                  <c:v> 4/22</c:v>
                </c:pt>
                <c:pt idx="78">
                  <c:v> 4/23</c:v>
                </c:pt>
                <c:pt idx="79">
                  <c:v> 4/24</c:v>
                </c:pt>
                <c:pt idx="80">
                  <c:v> 4/25</c:v>
                </c:pt>
                <c:pt idx="81">
                  <c:v> 4/26</c:v>
                </c:pt>
                <c:pt idx="82">
                  <c:v> 4/27</c:v>
                </c:pt>
                <c:pt idx="83">
                  <c:v> 4/28</c:v>
                </c:pt>
                <c:pt idx="84">
                  <c:v> 4/29</c:v>
                </c:pt>
                <c:pt idx="85">
                  <c:v> 4/30</c:v>
                </c:pt>
                <c:pt idx="86">
                  <c:v> 5/1</c:v>
                </c:pt>
                <c:pt idx="87">
                  <c:v> 5/2</c:v>
                </c:pt>
                <c:pt idx="88">
                  <c:v> 5/3</c:v>
                </c:pt>
                <c:pt idx="89">
                  <c:v> 5/4</c:v>
                </c:pt>
                <c:pt idx="90">
                  <c:v> 5/5</c:v>
                </c:pt>
                <c:pt idx="91">
                  <c:v> 5/6</c:v>
                </c:pt>
                <c:pt idx="92">
                  <c:v> 5/7</c:v>
                </c:pt>
                <c:pt idx="93">
                  <c:v> 5/8</c:v>
                </c:pt>
                <c:pt idx="94">
                  <c:v> 5/9</c:v>
                </c:pt>
                <c:pt idx="95">
                  <c:v> 5/10</c:v>
                </c:pt>
                <c:pt idx="96">
                  <c:v> 5/11</c:v>
                </c:pt>
                <c:pt idx="97">
                  <c:v> 5/12</c:v>
                </c:pt>
                <c:pt idx="98">
                  <c:v> 5/13</c:v>
                </c:pt>
                <c:pt idx="99">
                  <c:v> 5/14</c:v>
                </c:pt>
                <c:pt idx="100">
                  <c:v> 5/15</c:v>
                </c:pt>
                <c:pt idx="101">
                  <c:v> 5/16</c:v>
                </c:pt>
                <c:pt idx="102">
                  <c:v> 5/17</c:v>
                </c:pt>
                <c:pt idx="103">
                  <c:v> 5/18</c:v>
                </c:pt>
                <c:pt idx="104">
                  <c:v> 5/19</c:v>
                </c:pt>
                <c:pt idx="105">
                  <c:v> 5/20</c:v>
                </c:pt>
                <c:pt idx="106">
                  <c:v> 5/21</c:v>
                </c:pt>
                <c:pt idx="107">
                  <c:v> 5/22</c:v>
                </c:pt>
                <c:pt idx="108">
                  <c:v> 5/23</c:v>
                </c:pt>
                <c:pt idx="109">
                  <c:v> 5/24</c:v>
                </c:pt>
                <c:pt idx="110">
                  <c:v> 5/25</c:v>
                </c:pt>
                <c:pt idx="111">
                  <c:v> 5/26</c:v>
                </c:pt>
                <c:pt idx="112">
                  <c:v> 5/27</c:v>
                </c:pt>
                <c:pt idx="113">
                  <c:v> 5/28</c:v>
                </c:pt>
                <c:pt idx="114">
                  <c:v> 5/29</c:v>
                </c:pt>
                <c:pt idx="115">
                  <c:v> 5/30</c:v>
                </c:pt>
                <c:pt idx="116">
                  <c:v> 5/31</c:v>
                </c:pt>
                <c:pt idx="117">
                  <c:v> 6/1</c:v>
                </c:pt>
                <c:pt idx="118">
                  <c:v> 6/2</c:v>
                </c:pt>
                <c:pt idx="119">
                  <c:v> 6/3</c:v>
                </c:pt>
                <c:pt idx="120">
                  <c:v> 6/4</c:v>
                </c:pt>
                <c:pt idx="121">
                  <c:v> 6/5</c:v>
                </c:pt>
                <c:pt idx="122">
                  <c:v> 6/6</c:v>
                </c:pt>
                <c:pt idx="123">
                  <c:v> 6/7</c:v>
                </c:pt>
                <c:pt idx="124">
                  <c:v> 6/8</c:v>
                </c:pt>
                <c:pt idx="125">
                  <c:v> 6/9</c:v>
                </c:pt>
                <c:pt idx="126">
                  <c:v> 6/10</c:v>
                </c:pt>
                <c:pt idx="127">
                  <c:v> 6/11</c:v>
                </c:pt>
                <c:pt idx="128">
                  <c:v> 6/12</c:v>
                </c:pt>
                <c:pt idx="129">
                  <c:v> 6/13</c:v>
                </c:pt>
                <c:pt idx="130">
                  <c:v> 6/14</c:v>
                </c:pt>
                <c:pt idx="131">
                  <c:v> 6/15</c:v>
                </c:pt>
                <c:pt idx="132">
                  <c:v> 6/16</c:v>
                </c:pt>
                <c:pt idx="133">
                  <c:v> 6/17</c:v>
                </c:pt>
                <c:pt idx="134">
                  <c:v> 6/18</c:v>
                </c:pt>
                <c:pt idx="135">
                  <c:v> 6/19</c:v>
                </c:pt>
                <c:pt idx="136">
                  <c:v> 6/20</c:v>
                </c:pt>
                <c:pt idx="137">
                  <c:v> 6/21</c:v>
                </c:pt>
                <c:pt idx="138">
                  <c:v> 6/22</c:v>
                </c:pt>
                <c:pt idx="139">
                  <c:v> 6/23</c:v>
                </c:pt>
                <c:pt idx="140">
                  <c:v> 6/24</c:v>
                </c:pt>
                <c:pt idx="141">
                  <c:v> 6/25</c:v>
                </c:pt>
                <c:pt idx="142">
                  <c:v> 6/26</c:v>
                </c:pt>
                <c:pt idx="143">
                  <c:v> 6/27</c:v>
                </c:pt>
                <c:pt idx="144">
                  <c:v> 6/28</c:v>
                </c:pt>
                <c:pt idx="145">
                  <c:v> 6/29</c:v>
                </c:pt>
                <c:pt idx="146">
                  <c:v> 6/30</c:v>
                </c:pt>
                <c:pt idx="147">
                  <c:v> 7/1</c:v>
                </c:pt>
                <c:pt idx="148">
                  <c:v> 7/2</c:v>
                </c:pt>
                <c:pt idx="149">
                  <c:v> 7/3</c:v>
                </c:pt>
                <c:pt idx="150">
                  <c:v> 7/4</c:v>
                </c:pt>
                <c:pt idx="151">
                  <c:v> 7/5</c:v>
                </c:pt>
                <c:pt idx="152">
                  <c:v> 7/6</c:v>
                </c:pt>
                <c:pt idx="153">
                  <c:v> 7/7</c:v>
                </c:pt>
                <c:pt idx="154">
                  <c:v> 7/8</c:v>
                </c:pt>
                <c:pt idx="155">
                  <c:v> 7/9</c:v>
                </c:pt>
                <c:pt idx="156">
                  <c:v> 7/10</c:v>
                </c:pt>
                <c:pt idx="157">
                  <c:v> 7/11</c:v>
                </c:pt>
                <c:pt idx="158">
                  <c:v> 7/12</c:v>
                </c:pt>
                <c:pt idx="159">
                  <c:v> 7/13</c:v>
                </c:pt>
                <c:pt idx="160">
                  <c:v> 7/14</c:v>
                </c:pt>
                <c:pt idx="161">
                  <c:v> 7/15</c:v>
                </c:pt>
                <c:pt idx="162">
                  <c:v> 7/16</c:v>
                </c:pt>
                <c:pt idx="163">
                  <c:v> 7/17</c:v>
                </c:pt>
                <c:pt idx="164">
                  <c:v> 7/18</c:v>
                </c:pt>
                <c:pt idx="165">
                  <c:v> 7/19</c:v>
                </c:pt>
                <c:pt idx="166">
                  <c:v> 7/20</c:v>
                </c:pt>
                <c:pt idx="167">
                  <c:v> 7/21</c:v>
                </c:pt>
                <c:pt idx="168">
                  <c:v> 7/22</c:v>
                </c:pt>
                <c:pt idx="169">
                  <c:v> 7/23</c:v>
                </c:pt>
                <c:pt idx="170">
                  <c:v> 7/24</c:v>
                </c:pt>
                <c:pt idx="171">
                  <c:v> 7/25</c:v>
                </c:pt>
                <c:pt idx="172">
                  <c:v> 7/26</c:v>
                </c:pt>
                <c:pt idx="173">
                  <c:v> 7/27</c:v>
                </c:pt>
                <c:pt idx="174">
                  <c:v> 7/28</c:v>
                </c:pt>
                <c:pt idx="175">
                  <c:v> 7/29</c:v>
                </c:pt>
                <c:pt idx="176">
                  <c:v> 7/30</c:v>
                </c:pt>
                <c:pt idx="177">
                  <c:v> 7/31</c:v>
                </c:pt>
                <c:pt idx="178">
                  <c:v> 8/1</c:v>
                </c:pt>
                <c:pt idx="179">
                  <c:v> 8/2</c:v>
                </c:pt>
                <c:pt idx="180">
                  <c:v> 8/3</c:v>
                </c:pt>
                <c:pt idx="181">
                  <c:v> 8/4</c:v>
                </c:pt>
                <c:pt idx="182">
                  <c:v> 8/5</c:v>
                </c:pt>
                <c:pt idx="183">
                  <c:v> 8/6</c:v>
                </c:pt>
                <c:pt idx="184">
                  <c:v> 8/7</c:v>
                </c:pt>
                <c:pt idx="185">
                  <c:v> 8/8</c:v>
                </c:pt>
                <c:pt idx="186">
                  <c:v> 8/9</c:v>
                </c:pt>
                <c:pt idx="187">
                  <c:v> 8/10</c:v>
                </c:pt>
                <c:pt idx="188">
                  <c:v> 8/11</c:v>
                </c:pt>
                <c:pt idx="189">
                  <c:v> 8/12</c:v>
                </c:pt>
                <c:pt idx="190">
                  <c:v> 8/13</c:v>
                </c:pt>
                <c:pt idx="191">
                  <c:v> 8/14</c:v>
                </c:pt>
                <c:pt idx="192">
                  <c:v> 8/15</c:v>
                </c:pt>
                <c:pt idx="193">
                  <c:v> 8/16</c:v>
                </c:pt>
                <c:pt idx="194">
                  <c:v> 8/17</c:v>
                </c:pt>
                <c:pt idx="195">
                  <c:v> 8/18</c:v>
                </c:pt>
                <c:pt idx="196">
                  <c:v> 8/19</c:v>
                </c:pt>
                <c:pt idx="197">
                  <c:v> 8/20</c:v>
                </c:pt>
                <c:pt idx="198">
                  <c:v> 8/21</c:v>
                </c:pt>
                <c:pt idx="199">
                  <c:v> 8/22</c:v>
                </c:pt>
                <c:pt idx="200">
                  <c:v> 8/23</c:v>
                </c:pt>
                <c:pt idx="201">
                  <c:v> 8/24</c:v>
                </c:pt>
                <c:pt idx="202">
                  <c:v> 8/25</c:v>
                </c:pt>
                <c:pt idx="203">
                  <c:v> 8/26</c:v>
                </c:pt>
                <c:pt idx="204">
                  <c:v> 8/27</c:v>
                </c:pt>
                <c:pt idx="205">
                  <c:v> 8/28</c:v>
                </c:pt>
                <c:pt idx="206">
                  <c:v> 8/29</c:v>
                </c:pt>
                <c:pt idx="207">
                  <c:v> 8/30</c:v>
                </c:pt>
                <c:pt idx="208">
                  <c:v> 8/31</c:v>
                </c:pt>
                <c:pt idx="209">
                  <c:v> 9/1</c:v>
                </c:pt>
                <c:pt idx="210">
                  <c:v> 9/2</c:v>
                </c:pt>
                <c:pt idx="211">
                  <c:v> 9/3</c:v>
                </c:pt>
                <c:pt idx="212">
                  <c:v> 9/4</c:v>
                </c:pt>
                <c:pt idx="213">
                  <c:v> 9/5</c:v>
                </c:pt>
                <c:pt idx="214">
                  <c:v> 9/6</c:v>
                </c:pt>
                <c:pt idx="215">
                  <c:v> 9/7</c:v>
                </c:pt>
                <c:pt idx="216">
                  <c:v> 9/8</c:v>
                </c:pt>
                <c:pt idx="217">
                  <c:v> 9/9</c:v>
                </c:pt>
                <c:pt idx="218">
                  <c:v> 9/10</c:v>
                </c:pt>
                <c:pt idx="219">
                  <c:v> 9/11</c:v>
                </c:pt>
                <c:pt idx="220">
                  <c:v> 9/12</c:v>
                </c:pt>
                <c:pt idx="221">
                  <c:v> 9/13</c:v>
                </c:pt>
                <c:pt idx="222">
                  <c:v> 9/14</c:v>
                </c:pt>
                <c:pt idx="223">
                  <c:v> 9/15</c:v>
                </c:pt>
                <c:pt idx="224">
                  <c:v> 9/16</c:v>
                </c:pt>
                <c:pt idx="225">
                  <c:v> 9/17</c:v>
                </c:pt>
                <c:pt idx="226">
                  <c:v> 9/18</c:v>
                </c:pt>
                <c:pt idx="227">
                  <c:v> 9/19</c:v>
                </c:pt>
                <c:pt idx="228">
                  <c:v> 9/20</c:v>
                </c:pt>
                <c:pt idx="229">
                  <c:v> 9/21</c:v>
                </c:pt>
                <c:pt idx="230">
                  <c:v> 9/22</c:v>
                </c:pt>
                <c:pt idx="231">
                  <c:v> 9/23</c:v>
                </c:pt>
                <c:pt idx="232">
                  <c:v> 9/24</c:v>
                </c:pt>
                <c:pt idx="233">
                  <c:v> 9/25</c:v>
                </c:pt>
                <c:pt idx="234">
                  <c:v> 9/26</c:v>
                </c:pt>
                <c:pt idx="235">
                  <c:v> 9/27</c:v>
                </c:pt>
                <c:pt idx="236">
                  <c:v> 9/28</c:v>
                </c:pt>
                <c:pt idx="237">
                  <c:v> 9/29</c:v>
                </c:pt>
                <c:pt idx="238">
                  <c:v> 9/30</c:v>
                </c:pt>
                <c:pt idx="239">
                  <c:v> 10/1</c:v>
                </c:pt>
                <c:pt idx="240">
                  <c:v> 10/2</c:v>
                </c:pt>
                <c:pt idx="241">
                  <c:v> 10/3</c:v>
                </c:pt>
                <c:pt idx="242">
                  <c:v> 10/4</c:v>
                </c:pt>
                <c:pt idx="243">
                  <c:v> 10/5</c:v>
                </c:pt>
                <c:pt idx="244">
                  <c:v> 10/6</c:v>
                </c:pt>
                <c:pt idx="245">
                  <c:v> 10/7</c:v>
                </c:pt>
                <c:pt idx="246">
                  <c:v> 10/8</c:v>
                </c:pt>
                <c:pt idx="247">
                  <c:v> 10/9</c:v>
                </c:pt>
                <c:pt idx="248">
                  <c:v> 10/10</c:v>
                </c:pt>
                <c:pt idx="249">
                  <c:v> 10/11</c:v>
                </c:pt>
                <c:pt idx="250">
                  <c:v> 10/12</c:v>
                </c:pt>
                <c:pt idx="251">
                  <c:v> 10/13</c:v>
                </c:pt>
                <c:pt idx="252">
                  <c:v> 10/14</c:v>
                </c:pt>
                <c:pt idx="253">
                  <c:v> 10/15</c:v>
                </c:pt>
                <c:pt idx="254">
                  <c:v> 10/16</c:v>
                </c:pt>
                <c:pt idx="255">
                  <c:v> 10/17</c:v>
                </c:pt>
                <c:pt idx="256">
                  <c:v> 10/18</c:v>
                </c:pt>
                <c:pt idx="257">
                  <c:v> 10/19</c:v>
                </c:pt>
                <c:pt idx="258">
                  <c:v> 10/20</c:v>
                </c:pt>
                <c:pt idx="259">
                  <c:v> 10/21</c:v>
                </c:pt>
                <c:pt idx="260">
                  <c:v> 10/22</c:v>
                </c:pt>
                <c:pt idx="261">
                  <c:v> 10/23</c:v>
                </c:pt>
                <c:pt idx="262">
                  <c:v> 10/24</c:v>
                </c:pt>
                <c:pt idx="263">
                  <c:v> 10/25</c:v>
                </c:pt>
                <c:pt idx="264">
                  <c:v> 10/26</c:v>
                </c:pt>
                <c:pt idx="265">
                  <c:v> 10/27</c:v>
                </c:pt>
                <c:pt idx="266">
                  <c:v> 10/28</c:v>
                </c:pt>
                <c:pt idx="267">
                  <c:v> 10/29</c:v>
                </c:pt>
                <c:pt idx="268">
                  <c:v> 10/30</c:v>
                </c:pt>
                <c:pt idx="269">
                  <c:v> 10/31</c:v>
                </c:pt>
                <c:pt idx="270">
                  <c:v> 11/1</c:v>
                </c:pt>
                <c:pt idx="271">
                  <c:v> 11/2</c:v>
                </c:pt>
                <c:pt idx="272">
                  <c:v> 11/3</c:v>
                </c:pt>
                <c:pt idx="273">
                  <c:v> 11/4</c:v>
                </c:pt>
                <c:pt idx="274">
                  <c:v> 11/5</c:v>
                </c:pt>
                <c:pt idx="275">
                  <c:v> 11/6</c:v>
                </c:pt>
                <c:pt idx="276">
                  <c:v> 11/7</c:v>
                </c:pt>
                <c:pt idx="277">
                  <c:v> 11/8</c:v>
                </c:pt>
                <c:pt idx="278">
                  <c:v> 11/9</c:v>
                </c:pt>
                <c:pt idx="279">
                  <c:v> 11/10</c:v>
                </c:pt>
                <c:pt idx="280">
                  <c:v> 11/11</c:v>
                </c:pt>
                <c:pt idx="281">
                  <c:v> 11/12</c:v>
                </c:pt>
                <c:pt idx="282">
                  <c:v> 11/13</c:v>
                </c:pt>
                <c:pt idx="283">
                  <c:v> 11/14</c:v>
                </c:pt>
                <c:pt idx="284">
                  <c:v> 11/15</c:v>
                </c:pt>
                <c:pt idx="285">
                  <c:v> 11/16</c:v>
                </c:pt>
                <c:pt idx="286">
                  <c:v> 11/17</c:v>
                </c:pt>
                <c:pt idx="287">
                  <c:v> 11/18</c:v>
                </c:pt>
                <c:pt idx="288">
                  <c:v> 11/19</c:v>
                </c:pt>
                <c:pt idx="289">
                  <c:v> 11/20</c:v>
                </c:pt>
                <c:pt idx="290">
                  <c:v> 11/21</c:v>
                </c:pt>
                <c:pt idx="291">
                  <c:v> 11/22</c:v>
                </c:pt>
                <c:pt idx="292">
                  <c:v> 11/23</c:v>
                </c:pt>
                <c:pt idx="293">
                  <c:v> 11/24</c:v>
                </c:pt>
                <c:pt idx="294">
                  <c:v> 11/25</c:v>
                </c:pt>
                <c:pt idx="295">
                  <c:v> 11/26</c:v>
                </c:pt>
                <c:pt idx="296">
                  <c:v> 11/27</c:v>
                </c:pt>
                <c:pt idx="297">
                  <c:v> 11/28</c:v>
                </c:pt>
                <c:pt idx="298">
                  <c:v> 11/29</c:v>
                </c:pt>
                <c:pt idx="299">
                  <c:v> 11/30</c:v>
                </c:pt>
              </c:strCache>
            </c:strRef>
          </c:cat>
          <c:val>
            <c:numRef>
              <c:f>pcr_positive_daily!$C$2:$C$301</c:f>
              <c:numCache>
                <c:formatCode>General</c:formatCode>
                <c:ptCount val="30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2</c:v>
                </c:pt>
                <c:pt idx="10">
                  <c:v>3</c:v>
                </c:pt>
                <c:pt idx="11">
                  <c:v>3</c:v>
                </c:pt>
                <c:pt idx="12">
                  <c:v>3</c:v>
                </c:pt>
                <c:pt idx="13">
                  <c:v>6</c:v>
                </c:pt>
                <c:pt idx="14">
                  <c:v>7</c:v>
                </c:pt>
                <c:pt idx="15">
                  <c:v>9</c:v>
                </c:pt>
                <c:pt idx="16">
                  <c:v>10</c:v>
                </c:pt>
                <c:pt idx="17">
                  <c:v>11</c:v>
                </c:pt>
                <c:pt idx="18">
                  <c:v>13</c:v>
                </c:pt>
                <c:pt idx="19">
                  <c:v>14</c:v>
                </c:pt>
                <c:pt idx="20">
                  <c:v>15</c:v>
                </c:pt>
                <c:pt idx="21">
                  <c:v>16</c:v>
                </c:pt>
                <c:pt idx="22">
                  <c:v>20</c:v>
                </c:pt>
                <c:pt idx="23">
                  <c:v>22</c:v>
                </c:pt>
                <c:pt idx="24">
                  <c:v>23</c:v>
                </c:pt>
                <c:pt idx="25">
                  <c:v>23</c:v>
                </c:pt>
                <c:pt idx="26">
                  <c:v>24</c:v>
                </c:pt>
                <c:pt idx="27">
                  <c:v>24</c:v>
                </c:pt>
                <c:pt idx="28">
                  <c:v>27</c:v>
                </c:pt>
                <c:pt idx="29">
                  <c:v>30</c:v>
                </c:pt>
                <c:pt idx="30">
                  <c:v>28</c:v>
                </c:pt>
                <c:pt idx="31">
                  <c:v>33</c:v>
                </c:pt>
                <c:pt idx="32">
                  <c:v>33</c:v>
                </c:pt>
                <c:pt idx="33">
                  <c:v>31</c:v>
                </c:pt>
                <c:pt idx="34">
                  <c:v>26</c:v>
                </c:pt>
                <c:pt idx="35">
                  <c:v>29</c:v>
                </c:pt>
                <c:pt idx="36">
                  <c:v>32</c:v>
                </c:pt>
                <c:pt idx="37">
                  <c:v>35</c:v>
                </c:pt>
                <c:pt idx="38">
                  <c:v>36</c:v>
                </c:pt>
                <c:pt idx="39">
                  <c:v>41</c:v>
                </c:pt>
                <c:pt idx="40">
                  <c:v>46</c:v>
                </c:pt>
                <c:pt idx="41">
                  <c:v>46</c:v>
                </c:pt>
                <c:pt idx="42">
                  <c:v>49</c:v>
                </c:pt>
                <c:pt idx="43">
                  <c:v>50</c:v>
                </c:pt>
                <c:pt idx="44">
                  <c:v>55</c:v>
                </c:pt>
                <c:pt idx="45">
                  <c:v>57</c:v>
                </c:pt>
                <c:pt idx="46">
                  <c:v>54</c:v>
                </c:pt>
                <c:pt idx="47">
                  <c:v>55</c:v>
                </c:pt>
                <c:pt idx="48">
                  <c:v>57</c:v>
                </c:pt>
                <c:pt idx="49">
                  <c:v>56</c:v>
                </c:pt>
                <c:pt idx="50">
                  <c:v>57</c:v>
                </c:pt>
                <c:pt idx="51">
                  <c:v>60</c:v>
                </c:pt>
                <c:pt idx="52">
                  <c:v>59</c:v>
                </c:pt>
                <c:pt idx="53">
                  <c:v>59</c:v>
                </c:pt>
                <c:pt idx="54">
                  <c:v>59</c:v>
                </c:pt>
                <c:pt idx="55">
                  <c:v>60</c:v>
                </c:pt>
                <c:pt idx="56">
                  <c:v>62</c:v>
                </c:pt>
                <c:pt idx="57">
                  <c:v>64</c:v>
                </c:pt>
                <c:pt idx="58">
                  <c:v>69</c:v>
                </c:pt>
                <c:pt idx="59">
                  <c:v>70</c:v>
                </c:pt>
                <c:pt idx="60">
                  <c:v>79</c:v>
                </c:pt>
                <c:pt idx="61">
                  <c:v>80</c:v>
                </c:pt>
                <c:pt idx="62">
                  <c:v>99</c:v>
                </c:pt>
                <c:pt idx="63">
                  <c:v>109</c:v>
                </c:pt>
                <c:pt idx="64">
                  <c:v>117</c:v>
                </c:pt>
                <c:pt idx="65">
                  <c:v>122</c:v>
                </c:pt>
                <c:pt idx="66">
                  <c:v>129</c:v>
                </c:pt>
                <c:pt idx="67">
                  <c:v>135</c:v>
                </c:pt>
                <c:pt idx="68">
                  <c:v>152</c:v>
                </c:pt>
                <c:pt idx="69">
                  <c:v>168</c:v>
                </c:pt>
                <c:pt idx="70">
                  <c:v>193</c:v>
                </c:pt>
                <c:pt idx="71">
                  <c:v>207</c:v>
                </c:pt>
                <c:pt idx="72">
                  <c:v>211</c:v>
                </c:pt>
                <c:pt idx="73">
                  <c:v>217</c:v>
                </c:pt>
                <c:pt idx="74">
                  <c:v>231</c:v>
                </c:pt>
                <c:pt idx="75">
                  <c:v>232</c:v>
                </c:pt>
                <c:pt idx="76">
                  <c:v>241</c:v>
                </c:pt>
                <c:pt idx="77">
                  <c:v>259</c:v>
                </c:pt>
                <c:pt idx="78">
                  <c:v>263</c:v>
                </c:pt>
                <c:pt idx="79">
                  <c:v>287</c:v>
                </c:pt>
                <c:pt idx="80">
                  <c:v>296</c:v>
                </c:pt>
                <c:pt idx="81">
                  <c:v>300</c:v>
                </c:pt>
                <c:pt idx="82">
                  <c:v>305</c:v>
                </c:pt>
                <c:pt idx="83">
                  <c:v>306</c:v>
                </c:pt>
                <c:pt idx="84">
                  <c:v>308</c:v>
                </c:pt>
                <c:pt idx="85">
                  <c:v>328</c:v>
                </c:pt>
                <c:pt idx="86">
                  <c:v>324</c:v>
                </c:pt>
                <c:pt idx="87">
                  <c:v>321</c:v>
                </c:pt>
                <c:pt idx="88">
                  <c:v>308</c:v>
                </c:pt>
                <c:pt idx="89">
                  <c:v>309</c:v>
                </c:pt>
                <c:pt idx="90">
                  <c:v>308</c:v>
                </c:pt>
                <c:pt idx="91">
                  <c:v>300</c:v>
                </c:pt>
                <c:pt idx="92">
                  <c:v>287</c:v>
                </c:pt>
                <c:pt idx="93">
                  <c:v>266</c:v>
                </c:pt>
                <c:pt idx="94">
                  <c:v>267</c:v>
                </c:pt>
                <c:pt idx="95">
                  <c:v>249</c:v>
                </c:pt>
                <c:pt idx="96">
                  <c:v>243</c:v>
                </c:pt>
                <c:pt idx="97">
                  <c:v>259</c:v>
                </c:pt>
                <c:pt idx="98">
                  <c:v>245</c:v>
                </c:pt>
                <c:pt idx="99">
                  <c:v>237</c:v>
                </c:pt>
                <c:pt idx="100">
                  <c:v>232</c:v>
                </c:pt>
                <c:pt idx="101">
                  <c:v>230</c:v>
                </c:pt>
                <c:pt idx="102">
                  <c:v>228</c:v>
                </c:pt>
                <c:pt idx="103">
                  <c:v>213</c:v>
                </c:pt>
                <c:pt idx="104">
                  <c:v>210</c:v>
                </c:pt>
                <c:pt idx="105">
                  <c:v>195</c:v>
                </c:pt>
                <c:pt idx="106">
                  <c:v>176</c:v>
                </c:pt>
                <c:pt idx="107">
                  <c:v>174</c:v>
                </c:pt>
                <c:pt idx="108">
                  <c:v>168</c:v>
                </c:pt>
                <c:pt idx="109">
                  <c:v>165</c:v>
                </c:pt>
                <c:pt idx="110">
                  <c:v>155</c:v>
                </c:pt>
                <c:pt idx="111">
                  <c:v>147</c:v>
                </c:pt>
                <c:pt idx="112">
                  <c:v>136</c:v>
                </c:pt>
                <c:pt idx="113">
                  <c:v>131</c:v>
                </c:pt>
                <c:pt idx="114">
                  <c:v>123</c:v>
                </c:pt>
                <c:pt idx="115">
                  <c:v>119</c:v>
                </c:pt>
                <c:pt idx="116">
                  <c:v>115</c:v>
                </c:pt>
                <c:pt idx="117">
                  <c:v>113</c:v>
                </c:pt>
                <c:pt idx="118">
                  <c:v>101</c:v>
                </c:pt>
                <c:pt idx="119">
                  <c:v>102</c:v>
                </c:pt>
                <c:pt idx="120">
                  <c:v>98</c:v>
                </c:pt>
                <c:pt idx="121">
                  <c:v>99</c:v>
                </c:pt>
                <c:pt idx="122">
                  <c:v>98</c:v>
                </c:pt>
                <c:pt idx="123">
                  <c:v>99</c:v>
                </c:pt>
                <c:pt idx="124">
                  <c:v>92</c:v>
                </c:pt>
                <c:pt idx="125">
                  <c:v>91</c:v>
                </c:pt>
                <c:pt idx="126">
                  <c:v>88</c:v>
                </c:pt>
                <c:pt idx="127">
                  <c:v>82</c:v>
                </c:pt>
                <c:pt idx="128">
                  <c:v>76</c:v>
                </c:pt>
                <c:pt idx="129">
                  <c:v>73</c:v>
                </c:pt>
                <c:pt idx="130">
                  <c:v>71</c:v>
                </c:pt>
                <c:pt idx="131">
                  <c:v>80</c:v>
                </c:pt>
                <c:pt idx="132">
                  <c:v>70</c:v>
                </c:pt>
                <c:pt idx="133">
                  <c:v>62</c:v>
                </c:pt>
                <c:pt idx="134">
                  <c:v>62</c:v>
                </c:pt>
                <c:pt idx="135">
                  <c:v>61</c:v>
                </c:pt>
                <c:pt idx="136">
                  <c:v>59</c:v>
                </c:pt>
                <c:pt idx="137">
                  <c:v>59</c:v>
                </c:pt>
                <c:pt idx="138">
                  <c:v>62</c:v>
                </c:pt>
                <c:pt idx="139">
                  <c:v>60</c:v>
                </c:pt>
                <c:pt idx="140">
                  <c:v>58</c:v>
                </c:pt>
                <c:pt idx="141">
                  <c:v>51</c:v>
                </c:pt>
                <c:pt idx="142">
                  <c:v>48</c:v>
                </c:pt>
                <c:pt idx="143">
                  <c:v>45</c:v>
                </c:pt>
                <c:pt idx="144">
                  <c:v>43</c:v>
                </c:pt>
                <c:pt idx="145">
                  <c:v>42</c:v>
                </c:pt>
                <c:pt idx="146">
                  <c:v>40</c:v>
                </c:pt>
                <c:pt idx="147">
                  <c:v>37</c:v>
                </c:pt>
                <c:pt idx="148">
                  <c:v>33</c:v>
                </c:pt>
                <c:pt idx="149">
                  <c:v>32</c:v>
                </c:pt>
                <c:pt idx="150">
                  <c:v>33</c:v>
                </c:pt>
                <c:pt idx="151">
                  <c:v>34</c:v>
                </c:pt>
                <c:pt idx="152">
                  <c:v>36</c:v>
                </c:pt>
                <c:pt idx="153">
                  <c:v>35</c:v>
                </c:pt>
                <c:pt idx="154">
                  <c:v>38</c:v>
                </c:pt>
                <c:pt idx="155">
                  <c:v>31</c:v>
                </c:pt>
                <c:pt idx="156">
                  <c:v>33</c:v>
                </c:pt>
                <c:pt idx="157">
                  <c:v>32</c:v>
                </c:pt>
                <c:pt idx="158">
                  <c:v>34</c:v>
                </c:pt>
                <c:pt idx="159">
                  <c:v>40</c:v>
                </c:pt>
                <c:pt idx="160">
                  <c:v>38</c:v>
                </c:pt>
                <c:pt idx="161">
                  <c:v>37</c:v>
                </c:pt>
                <c:pt idx="162">
                  <c:v>39</c:v>
                </c:pt>
                <c:pt idx="163">
                  <c:v>41</c:v>
                </c:pt>
                <c:pt idx="164">
                  <c:v>43</c:v>
                </c:pt>
                <c:pt idx="165">
                  <c:v>47</c:v>
                </c:pt>
                <c:pt idx="166">
                  <c:v>52</c:v>
                </c:pt>
                <c:pt idx="167">
                  <c:v>55</c:v>
                </c:pt>
                <c:pt idx="168">
                  <c:v>59</c:v>
                </c:pt>
                <c:pt idx="169">
                  <c:v>68</c:v>
                </c:pt>
                <c:pt idx="170">
                  <c:v>64</c:v>
                </c:pt>
                <c:pt idx="171">
                  <c:v>66</c:v>
                </c:pt>
                <c:pt idx="172">
                  <c:v>67</c:v>
                </c:pt>
                <c:pt idx="173">
                  <c:v>76</c:v>
                </c:pt>
                <c:pt idx="174">
                  <c:v>81</c:v>
                </c:pt>
                <c:pt idx="175">
                  <c:v>90</c:v>
                </c:pt>
                <c:pt idx="176">
                  <c:v>87</c:v>
                </c:pt>
                <c:pt idx="177">
                  <c:v>80</c:v>
                </c:pt>
                <c:pt idx="178">
                  <c:v>83</c:v>
                </c:pt>
                <c:pt idx="179">
                  <c:v>87</c:v>
                </c:pt>
                <c:pt idx="180">
                  <c:v>88</c:v>
                </c:pt>
                <c:pt idx="181">
                  <c:v>104</c:v>
                </c:pt>
                <c:pt idx="182">
                  <c:v>115</c:v>
                </c:pt>
                <c:pt idx="183">
                  <c:v>131</c:v>
                </c:pt>
                <c:pt idx="184">
                  <c:v>140</c:v>
                </c:pt>
                <c:pt idx="185">
                  <c:v>156</c:v>
                </c:pt>
                <c:pt idx="186">
                  <c:v>162</c:v>
                </c:pt>
                <c:pt idx="187">
                  <c:v>171</c:v>
                </c:pt>
                <c:pt idx="188">
                  <c:v>177</c:v>
                </c:pt>
                <c:pt idx="189">
                  <c:v>203</c:v>
                </c:pt>
                <c:pt idx="190">
                  <c:v>211</c:v>
                </c:pt>
                <c:pt idx="191">
                  <c:v>229</c:v>
                </c:pt>
                <c:pt idx="192">
                  <c:v>232</c:v>
                </c:pt>
                <c:pt idx="193">
                  <c:v>243</c:v>
                </c:pt>
                <c:pt idx="194">
                  <c:v>243</c:v>
                </c:pt>
                <c:pt idx="195">
                  <c:v>239</c:v>
                </c:pt>
                <c:pt idx="196">
                  <c:v>237</c:v>
                </c:pt>
                <c:pt idx="197">
                  <c:v>243</c:v>
                </c:pt>
                <c:pt idx="198">
                  <c:v>243</c:v>
                </c:pt>
                <c:pt idx="199">
                  <c:v>254</c:v>
                </c:pt>
                <c:pt idx="200">
                  <c:v>259</c:v>
                </c:pt>
                <c:pt idx="201">
                  <c:v>252</c:v>
                </c:pt>
                <c:pt idx="202">
                  <c:v>246</c:v>
                </c:pt>
                <c:pt idx="203">
                  <c:v>238</c:v>
                </c:pt>
                <c:pt idx="204">
                  <c:v>227</c:v>
                </c:pt>
                <c:pt idx="205">
                  <c:v>230</c:v>
                </c:pt>
                <c:pt idx="206">
                  <c:v>234</c:v>
                </c:pt>
                <c:pt idx="207">
                  <c:v>236</c:v>
                </c:pt>
                <c:pt idx="208">
                  <c:v>234</c:v>
                </c:pt>
                <c:pt idx="209">
                  <c:v>225</c:v>
                </c:pt>
                <c:pt idx="210">
                  <c:v>218</c:v>
                </c:pt>
                <c:pt idx="211">
                  <c:v>214</c:v>
                </c:pt>
                <c:pt idx="212">
                  <c:v>210</c:v>
                </c:pt>
                <c:pt idx="213">
                  <c:v>211</c:v>
                </c:pt>
                <c:pt idx="214">
                  <c:v>209</c:v>
                </c:pt>
                <c:pt idx="215">
                  <c:v>202</c:v>
                </c:pt>
                <c:pt idx="216">
                  <c:v>202</c:v>
                </c:pt>
                <c:pt idx="217">
                  <c:v>198</c:v>
                </c:pt>
                <c:pt idx="218">
                  <c:v>191</c:v>
                </c:pt>
                <c:pt idx="219">
                  <c:v>190</c:v>
                </c:pt>
                <c:pt idx="220">
                  <c:v>180</c:v>
                </c:pt>
                <c:pt idx="221">
                  <c:v>185</c:v>
                </c:pt>
                <c:pt idx="222">
                  <c:v>174</c:v>
                </c:pt>
                <c:pt idx="223">
                  <c:v>178</c:v>
                </c:pt>
                <c:pt idx="224">
                  <c:v>167</c:v>
                </c:pt>
                <c:pt idx="225">
                  <c:v>170</c:v>
                </c:pt>
                <c:pt idx="226">
                  <c:v>161</c:v>
                </c:pt>
                <c:pt idx="227">
                  <c:v>159</c:v>
                </c:pt>
                <c:pt idx="228">
                  <c:v>163</c:v>
                </c:pt>
                <c:pt idx="229">
                  <c:v>164</c:v>
                </c:pt>
                <c:pt idx="230">
                  <c:v>165</c:v>
                </c:pt>
                <c:pt idx="231">
                  <c:v>166</c:v>
                </c:pt>
                <c:pt idx="232">
                  <c:v>163</c:v>
                </c:pt>
                <c:pt idx="233">
                  <c:v>156</c:v>
                </c:pt>
                <c:pt idx="234">
                  <c:v>160</c:v>
                </c:pt>
                <c:pt idx="235">
                  <c:v>159</c:v>
                </c:pt>
                <c:pt idx="236">
                  <c:v>161</c:v>
                </c:pt>
                <c:pt idx="237">
                  <c:v>151</c:v>
                </c:pt>
                <c:pt idx="238">
                  <c:v>151</c:v>
                </c:pt>
                <c:pt idx="239">
                  <c:v>145</c:v>
                </c:pt>
                <c:pt idx="240">
                  <c:v>137</c:v>
                </c:pt>
                <c:pt idx="241">
                  <c:v>133</c:v>
                </c:pt>
                <c:pt idx="242">
                  <c:v>131</c:v>
                </c:pt>
                <c:pt idx="243">
                  <c:v>140</c:v>
                </c:pt>
                <c:pt idx="244">
                  <c:v>141</c:v>
                </c:pt>
                <c:pt idx="245">
                  <c:v>143</c:v>
                </c:pt>
                <c:pt idx="246">
                  <c:v>141</c:v>
                </c:pt>
                <c:pt idx="247">
                  <c:v>147</c:v>
                </c:pt>
                <c:pt idx="248">
                  <c:v>145</c:v>
                </c:pt>
                <c:pt idx="249">
                  <c:v>146</c:v>
                </c:pt>
                <c:pt idx="250">
                  <c:v>148</c:v>
                </c:pt>
                <c:pt idx="251">
                  <c:v>150</c:v>
                </c:pt>
                <c:pt idx="252">
                  <c:v>146</c:v>
                </c:pt>
                <c:pt idx="253">
                  <c:v>148</c:v>
                </c:pt>
                <c:pt idx="254">
                  <c:v>148</c:v>
                </c:pt>
                <c:pt idx="255">
                  <c:v>145</c:v>
                </c:pt>
                <c:pt idx="256">
                  <c:v>144</c:v>
                </c:pt>
                <c:pt idx="257">
                  <c:v>143</c:v>
                </c:pt>
                <c:pt idx="258">
                  <c:v>150</c:v>
                </c:pt>
                <c:pt idx="259">
                  <c:v>150</c:v>
                </c:pt>
                <c:pt idx="260">
                  <c:v>151</c:v>
                </c:pt>
                <c:pt idx="261">
                  <c:v>155</c:v>
                </c:pt>
                <c:pt idx="262">
                  <c:v>159</c:v>
                </c:pt>
                <c:pt idx="263">
                  <c:v>162</c:v>
                </c:pt>
                <c:pt idx="264">
                  <c:v>165</c:v>
                </c:pt>
                <c:pt idx="265">
                  <c:v>166</c:v>
                </c:pt>
                <c:pt idx="266">
                  <c:v>161</c:v>
                </c:pt>
                <c:pt idx="267">
                  <c:v>156</c:v>
                </c:pt>
                <c:pt idx="268">
                  <c:v>161</c:v>
                </c:pt>
                <c:pt idx="269">
                  <c:v>160</c:v>
                </c:pt>
                <c:pt idx="270">
                  <c:v>163</c:v>
                </c:pt>
                <c:pt idx="271">
                  <c:v>163</c:v>
                </c:pt>
                <c:pt idx="272">
                  <c:v>165</c:v>
                </c:pt>
                <c:pt idx="273">
                  <c:v>183</c:v>
                </c:pt>
                <c:pt idx="274">
                  <c:v>189</c:v>
                </c:pt>
                <c:pt idx="275">
                  <c:v>194</c:v>
                </c:pt>
                <c:pt idx="276">
                  <c:v>196</c:v>
                </c:pt>
                <c:pt idx="277">
                  <c:v>204</c:v>
                </c:pt>
                <c:pt idx="278">
                  <c:v>208</c:v>
                </c:pt>
                <c:pt idx="279">
                  <c:v>204</c:v>
                </c:pt>
                <c:pt idx="280">
                  <c:v>226</c:v>
                </c:pt>
                <c:pt idx="281">
                  <c:v>231</c:v>
                </c:pt>
                <c:pt idx="282">
                  <c:v>234</c:v>
                </c:pt>
                <c:pt idx="283">
                  <c:v>243</c:v>
                </c:pt>
                <c:pt idx="284">
                  <c:v>251</c:v>
                </c:pt>
                <c:pt idx="285">
                  <c:v>272</c:v>
                </c:pt>
                <c:pt idx="286">
                  <c:v>276</c:v>
                </c:pt>
                <c:pt idx="287">
                  <c:v>280</c:v>
                </c:pt>
                <c:pt idx="288">
                  <c:v>291</c:v>
                </c:pt>
                <c:pt idx="289">
                  <c:v>313</c:v>
                </c:pt>
                <c:pt idx="290">
                  <c:v>323</c:v>
                </c:pt>
                <c:pt idx="291">
                  <c:v>331</c:v>
                </c:pt>
                <c:pt idx="292">
                  <c:v>345</c:v>
                </c:pt>
                <c:pt idx="293">
                  <c:v>376</c:v>
                </c:pt>
                <c:pt idx="294">
                  <c:v>410</c:v>
                </c:pt>
                <c:pt idx="295">
                  <c:v>435</c:v>
                </c:pt>
                <c:pt idx="296">
                  <c:v>440</c:v>
                </c:pt>
                <c:pt idx="297">
                  <c:v>462</c:v>
                </c:pt>
                <c:pt idx="298">
                  <c:v>472</c:v>
                </c:pt>
                <c:pt idx="299">
                  <c:v>4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A5B-4F8C-9B47-98A123A3E96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-25"/>
        <c:axId val="1446499567"/>
        <c:axId val="1446499983"/>
      </c:barChart>
      <c:catAx>
        <c:axId val="144649956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446499983"/>
        <c:crosses val="autoZero"/>
        <c:auto val="1"/>
        <c:lblAlgn val="ctr"/>
        <c:lblOffset val="100"/>
        <c:noMultiLvlLbl val="0"/>
      </c:catAx>
      <c:valAx>
        <c:axId val="1446499983"/>
        <c:scaling>
          <c:orientation val="minMax"/>
          <c:max val="3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446499567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>
                  <a:lumMod val="95000"/>
                  <a:lumOff val="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chemeClr val="tx1">
              <a:lumMod val="95000"/>
              <a:lumOff val="5000"/>
            </a:schemeClr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9456A95-A004-46B3-93EF-86358ADFA46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AEE1C3A5-5DEC-4E35-A560-402D7F18458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48715BF-F88C-4FC8-85C0-DF832E8A5E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C2D22-81C4-4C5E-AB31-41E7111D6564}" type="datetimeFigureOut">
              <a:rPr kumimoji="1" lang="ja-JP" altLang="en-US" smtClean="0"/>
              <a:t>2020/12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FFD0DE5-D199-46AC-A922-50ADC95CDC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ABCD777-044E-480C-B04F-F63981F1CB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4C6CBE-70A9-42D1-A6DA-147797FDDB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20553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0B7DAA6-C967-4219-A866-F5E3CF036B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3AB488F-382C-4831-9623-92A6667862F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C15B7AF-3382-490B-80A8-2464AFA67D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C2D22-81C4-4C5E-AB31-41E7111D6564}" type="datetimeFigureOut">
              <a:rPr kumimoji="1" lang="ja-JP" altLang="en-US" smtClean="0"/>
              <a:t>2020/12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3BEC51A-0360-4DAF-900F-D92FF36F11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8637B0A-E649-4798-B732-1B86E13924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4C6CBE-70A9-42D1-A6DA-147797FDDB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67215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B8D4CD66-5A32-4671-9AB3-098581BE046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E1653C0-9A04-4A80-98AB-D190BFB219A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2E6FBC6-67B5-4458-BCA5-9BDF1D9DBF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C2D22-81C4-4C5E-AB31-41E7111D6564}" type="datetimeFigureOut">
              <a:rPr kumimoji="1" lang="ja-JP" altLang="en-US" smtClean="0"/>
              <a:t>2020/12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A196785-D0B1-44ED-83CA-D32B2E535C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3517CF4-312F-4B0E-9B6F-DC9942FF55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4C6CBE-70A9-42D1-A6DA-147797FDDB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04662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D27A828-8D86-4FB4-B279-4683631108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2C2C04A-4838-4F91-B652-A1FC1F396B4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ED1346A-34CC-4DBB-9D22-B25671CF4D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C2D22-81C4-4C5E-AB31-41E7111D6564}" type="datetimeFigureOut">
              <a:rPr kumimoji="1" lang="ja-JP" altLang="en-US" smtClean="0"/>
              <a:t>2020/12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2EB41BE-12AC-4B6E-85ED-2866401FE0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A6D9C63-29CB-45DE-9BDC-EC645BF1E7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4C6CBE-70A9-42D1-A6DA-147797FDDB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08210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71BCDBB-2531-440B-B84A-83CF078F58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44F4AAF-CA1E-4CF9-ACD0-11054FC5C5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CA80204-32AB-4F0F-8F83-0F68B6B1FE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C2D22-81C4-4C5E-AB31-41E7111D6564}" type="datetimeFigureOut">
              <a:rPr kumimoji="1" lang="ja-JP" altLang="en-US" smtClean="0"/>
              <a:t>2020/12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56352E5-F370-4270-A7BD-97F9690D12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682491F-83C9-4DAC-969B-F8E43D4268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4C6CBE-70A9-42D1-A6DA-147797FDDB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2661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46D63E7-F761-41FD-BC0D-BE498A9844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84BBC2F-BC0C-4BD9-835B-ACA66953201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2BF9D84-AB27-4943-9885-8A17DC48B2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EFE0975-1806-48B9-8B2C-51BDD125A9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C2D22-81C4-4C5E-AB31-41E7111D6564}" type="datetimeFigureOut">
              <a:rPr kumimoji="1" lang="ja-JP" altLang="en-US" smtClean="0"/>
              <a:t>2020/12/2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E5B7B65-77E4-4168-B510-0E5575CA75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593C0F7-24C7-4E3F-9BD9-BCD1C3B67B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4C6CBE-70A9-42D1-A6DA-147797FDDB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69996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A8F3913-B967-4CC6-BD08-FCF250927E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2272E4F-7A49-4FAD-8425-07E0781D5F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5AECF73-2C38-46A8-9231-EE4DE90931D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3080FC3F-AE63-42EC-A370-DDB049C92A1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9D3F1816-E4E9-487A-9160-318C3ADABCE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9454DE8A-424B-4BFA-8409-A17CE6B3D9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C2D22-81C4-4C5E-AB31-41E7111D6564}" type="datetimeFigureOut">
              <a:rPr kumimoji="1" lang="ja-JP" altLang="en-US" smtClean="0"/>
              <a:t>2020/12/2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72302AC0-F13B-48D7-B8F9-3E3520FBB2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73E5F7DA-552A-4512-A74E-B1653200F8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4C6CBE-70A9-42D1-A6DA-147797FDDB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4272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DC7BEB1-8C0F-466C-BF78-320F3DAFCB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B760E766-E2FD-4F11-8A83-995DEFB98A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C2D22-81C4-4C5E-AB31-41E7111D6564}" type="datetimeFigureOut">
              <a:rPr kumimoji="1" lang="ja-JP" altLang="en-US" smtClean="0"/>
              <a:t>2020/12/2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5F0F57BE-6530-4B83-A92A-9BB0A9FC36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CB499E97-439E-4B03-8678-4E910EC483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4C6CBE-70A9-42D1-A6DA-147797FDDB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97710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820A98A1-1259-4EF6-B145-C047A9C171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C2D22-81C4-4C5E-AB31-41E7111D6564}" type="datetimeFigureOut">
              <a:rPr kumimoji="1" lang="ja-JP" altLang="en-US" smtClean="0"/>
              <a:t>2020/12/2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05755B46-04E4-4CD3-92F0-A96BF35182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FE32CB5C-9DB1-4FA9-8292-311F22F753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4C6CBE-70A9-42D1-A6DA-147797FDDB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81552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086C10D-73B6-40C8-9318-46FF2D11EE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6F27766-C775-4558-A155-B7C5D2ED70E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70FF05A-6B43-4424-8432-F5899C60453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673554F-82E1-4626-9154-07A413B74C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C2D22-81C4-4C5E-AB31-41E7111D6564}" type="datetimeFigureOut">
              <a:rPr kumimoji="1" lang="ja-JP" altLang="en-US" smtClean="0"/>
              <a:t>2020/12/2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88168C5-2B6B-4067-9CF0-9DFFE18FD1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97DC345-D912-4C77-B16C-457A65EEDA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4C6CBE-70A9-42D1-A6DA-147797FDDB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22387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7D99A34-041C-4EC6-917C-BC2E012776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7AE37049-099D-43F3-8C23-C2EABF69EFA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09E408C-6E6C-4AD4-AEC1-C9399611994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DF9518F-A88F-467F-86DE-7D2288F610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C2D22-81C4-4C5E-AB31-41E7111D6564}" type="datetimeFigureOut">
              <a:rPr kumimoji="1" lang="ja-JP" altLang="en-US" smtClean="0"/>
              <a:t>2020/12/2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9E32FF1-536A-42F3-AA81-7ECED4B0A4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D25425B-DB59-4BC0-B750-58FF37B9EE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4C6CBE-70A9-42D1-A6DA-147797FDDB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32276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9C8B0919-57B4-4932-81BB-1F8937B3CD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5F67229-0C06-4146-81D7-36561F26AD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0A4C4D6-9DD6-4BB9-B7BA-E23F767A68C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3C2D22-81C4-4C5E-AB31-41E7111D6564}" type="datetimeFigureOut">
              <a:rPr kumimoji="1" lang="ja-JP" altLang="en-US" smtClean="0"/>
              <a:t>2020/12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E38E81C-9971-4F75-8D39-5177665EA96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5A4454A-5565-4E04-8B57-CD8AA83D697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4C6CBE-70A9-42D1-A6DA-147797FDDB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1466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4C7038FF-DEFE-4590-80E9-4D93922978C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92047684"/>
              </p:ext>
            </p:extLst>
          </p:nvPr>
        </p:nvGraphicFramePr>
        <p:xfrm>
          <a:off x="396240" y="680720"/>
          <a:ext cx="11369040" cy="55270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6614EF1C-D738-4A81-98AD-2ABD74FCC58F}"/>
              </a:ext>
            </a:extLst>
          </p:cNvPr>
          <p:cNvSpPr txBox="1"/>
          <p:nvPr/>
        </p:nvSpPr>
        <p:spPr>
          <a:xfrm rot="16200000">
            <a:off x="-629178" y="2915920"/>
            <a:ext cx="17732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patients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55CBBAC5-8E86-412A-B3CB-35D04A8A10CE}"/>
              </a:ext>
            </a:extLst>
          </p:cNvPr>
          <p:cNvSpPr txBox="1"/>
          <p:nvPr/>
        </p:nvSpPr>
        <p:spPr>
          <a:xfrm>
            <a:off x="3495674" y="6372225"/>
            <a:ext cx="8096251" cy="3429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2. The time point of the survey and COVID-19 situations in Japan in 2020.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" name="直線矢印コネクタ 7">
            <a:extLst>
              <a:ext uri="{FF2B5EF4-FFF2-40B4-BE49-F238E27FC236}">
                <a16:creationId xmlns:a16="http://schemas.microsoft.com/office/drawing/2014/main" id="{1945CC8C-8D1C-4015-A729-396475AC5434}"/>
              </a:ext>
            </a:extLst>
          </p:cNvPr>
          <p:cNvCxnSpPr/>
          <p:nvPr/>
        </p:nvCxnSpPr>
        <p:spPr>
          <a:xfrm>
            <a:off x="2586990" y="3444240"/>
            <a:ext cx="0" cy="1543050"/>
          </a:xfrm>
          <a:prstGeom prst="straightConnector1">
            <a:avLst/>
          </a:prstGeom>
          <a:ln w="28575">
            <a:solidFill>
              <a:schemeClr val="tx1"/>
            </a:solidFill>
            <a:headEnd w="lg" len="lg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矢印コネクタ 8">
            <a:extLst>
              <a:ext uri="{FF2B5EF4-FFF2-40B4-BE49-F238E27FC236}">
                <a16:creationId xmlns:a16="http://schemas.microsoft.com/office/drawing/2014/main" id="{24FA7DEE-138D-4900-9430-6E488C5C43F4}"/>
              </a:ext>
            </a:extLst>
          </p:cNvPr>
          <p:cNvCxnSpPr/>
          <p:nvPr/>
        </p:nvCxnSpPr>
        <p:spPr>
          <a:xfrm>
            <a:off x="4801870" y="3219236"/>
            <a:ext cx="0" cy="1543050"/>
          </a:xfrm>
          <a:prstGeom prst="straightConnector1">
            <a:avLst/>
          </a:prstGeom>
          <a:ln w="28575">
            <a:solidFill>
              <a:schemeClr val="tx1"/>
            </a:solidFill>
            <a:headEnd w="lg" len="lg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矢印コネクタ 9">
            <a:extLst>
              <a:ext uri="{FF2B5EF4-FFF2-40B4-BE49-F238E27FC236}">
                <a16:creationId xmlns:a16="http://schemas.microsoft.com/office/drawing/2014/main" id="{87E660E2-CCE4-4386-96F7-C8A17955C4EB}"/>
              </a:ext>
            </a:extLst>
          </p:cNvPr>
          <p:cNvCxnSpPr/>
          <p:nvPr/>
        </p:nvCxnSpPr>
        <p:spPr>
          <a:xfrm>
            <a:off x="7543799" y="1227876"/>
            <a:ext cx="0" cy="1543050"/>
          </a:xfrm>
          <a:prstGeom prst="straightConnector1">
            <a:avLst/>
          </a:prstGeom>
          <a:ln w="28575">
            <a:solidFill>
              <a:schemeClr val="tx1"/>
            </a:solidFill>
            <a:headEnd w="lg" len="lg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矢印コネクタ 10">
            <a:extLst>
              <a:ext uri="{FF2B5EF4-FFF2-40B4-BE49-F238E27FC236}">
                <a16:creationId xmlns:a16="http://schemas.microsoft.com/office/drawing/2014/main" id="{1181D731-360D-4050-948D-FB7C3C39DDA1}"/>
              </a:ext>
            </a:extLst>
          </p:cNvPr>
          <p:cNvCxnSpPr/>
          <p:nvPr/>
        </p:nvCxnSpPr>
        <p:spPr>
          <a:xfrm>
            <a:off x="10794999" y="1427051"/>
            <a:ext cx="0" cy="1543050"/>
          </a:xfrm>
          <a:prstGeom prst="straightConnector1">
            <a:avLst/>
          </a:prstGeom>
          <a:ln w="28575">
            <a:solidFill>
              <a:schemeClr val="tx1"/>
            </a:solidFill>
            <a:headEnd w="lg" len="lg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6598665-3EE4-4805-80D2-78E01F144778}"/>
              </a:ext>
            </a:extLst>
          </p:cNvPr>
          <p:cNvSpPr txBox="1"/>
          <p:nvPr/>
        </p:nvSpPr>
        <p:spPr>
          <a:xfrm>
            <a:off x="2372081" y="2569991"/>
            <a:ext cx="48442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1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F28CA180-1822-4E29-8FCF-F4933096E46F}"/>
              </a:ext>
            </a:extLst>
          </p:cNvPr>
          <p:cNvSpPr txBox="1"/>
          <p:nvPr/>
        </p:nvSpPr>
        <p:spPr>
          <a:xfrm>
            <a:off x="4603825" y="2467558"/>
            <a:ext cx="4844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2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95CED43E-0003-4AEE-94A3-4862CB6510D2}"/>
              </a:ext>
            </a:extLst>
          </p:cNvPr>
          <p:cNvSpPr txBox="1"/>
          <p:nvPr/>
        </p:nvSpPr>
        <p:spPr>
          <a:xfrm>
            <a:off x="7301585" y="504190"/>
            <a:ext cx="48442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3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16138E56-A2B7-4883-88E7-00C569CE8F98}"/>
              </a:ext>
            </a:extLst>
          </p:cNvPr>
          <p:cNvSpPr txBox="1"/>
          <p:nvPr/>
        </p:nvSpPr>
        <p:spPr>
          <a:xfrm>
            <a:off x="10552785" y="640785"/>
            <a:ext cx="48442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4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CA41FA2B-D3E1-4513-A63E-D7236330E9A3}"/>
              </a:ext>
            </a:extLst>
          </p:cNvPr>
          <p:cNvSpPr txBox="1"/>
          <p:nvPr/>
        </p:nvSpPr>
        <p:spPr>
          <a:xfrm>
            <a:off x="1882775" y="2867668"/>
            <a:ext cx="1463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–22 March 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0968572E-A5BC-47E9-9252-F988AA10E0D7}"/>
              </a:ext>
            </a:extLst>
          </p:cNvPr>
          <p:cNvSpPr txBox="1"/>
          <p:nvPr/>
        </p:nvSpPr>
        <p:spPr>
          <a:xfrm>
            <a:off x="4292600" y="2734701"/>
            <a:ext cx="1463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22–26 May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63401DD7-5127-449C-985C-A432FF424282}"/>
              </a:ext>
            </a:extLst>
          </p:cNvPr>
          <p:cNvSpPr txBox="1"/>
          <p:nvPr/>
        </p:nvSpPr>
        <p:spPr>
          <a:xfrm>
            <a:off x="6897866" y="842525"/>
            <a:ext cx="1463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7-12 August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8D7964A8-BF4F-4789-8B4B-22757FD72E27}"/>
              </a:ext>
            </a:extLst>
          </p:cNvPr>
          <p:cNvSpPr txBox="1"/>
          <p:nvPr/>
        </p:nvSpPr>
        <p:spPr>
          <a:xfrm>
            <a:off x="9999346" y="953197"/>
            <a:ext cx="1738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6-12 November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135564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32</Words>
  <Application>Microsoft Office PowerPoint</Application>
  <PresentationFormat>ワイド画面</PresentationFormat>
  <Paragraphs>1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々木　那津</dc:creator>
  <cp:lastModifiedBy>佐々木　那津</cp:lastModifiedBy>
  <cp:revision>1</cp:revision>
  <dcterms:created xsi:type="dcterms:W3CDTF">2020-12-27T22:08:09Z</dcterms:created>
  <dcterms:modified xsi:type="dcterms:W3CDTF">2020-12-27T22:34:14Z</dcterms:modified>
</cp:coreProperties>
</file>